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_rels/notesSlide9.xml.rels" ContentType="application/vnd.openxmlformats-package.relationships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9.xml" ContentType="application/vnd.openxmlformats-officedocument.presentationml.notesSlid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png" ContentType="image/png"/>
  <Override PartName="/ppt/media/image4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notesMasterIdLst>
    <p:notesMasterId r:id="rId4"/>
  </p:notes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slide" Target="slides/slide5.xml"/><Relationship Id="rId10" Type="http://schemas.openxmlformats.org/officeDocument/2006/relationships/slide" Target="slides/slide6.xml"/><Relationship Id="rId11" Type="http://schemas.openxmlformats.org/officeDocument/2006/relationships/slide" Target="slides/slide7.xml"/><Relationship Id="rId12" Type="http://schemas.openxmlformats.org/officeDocument/2006/relationships/slide" Target="slides/slide8.xml"/><Relationship Id="rId13" Type="http://schemas.openxmlformats.org/officeDocument/2006/relationships/slide" Target="slides/slide9.xml"/><Relationship Id="rId14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3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91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 type="dt" idx="7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ffffff"/>
                </a:solidFill>
                <a:latin typeface="Times New Roman"/>
              </a:rPr>
              <a:t>Click to move the slide</a:t>
            </a: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4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PlaceHolder 5"/>
          <p:cNvSpPr>
            <a:spLocks noGrp="1"/>
          </p:cNvSpPr>
          <p:nvPr>
            <p:ph type="ftr" idx="8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PlaceHolder 6"/>
          <p:cNvSpPr>
            <a:spLocks noGrp="1"/>
          </p:cNvSpPr>
          <p:nvPr>
            <p:ph type="sldNum" idx="9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FF89AB-23EC-437F-A749-B49997765AE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1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Calibri"/>
              <a:ea typeface="맑은 고딕"/>
            </a:endParaRPr>
          </a:p>
        </p:txBody>
      </p:sp>
      <p:sp>
        <p:nvSpPr>
          <p:cNvPr id="212" name="슬라이드 번호 개체 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4AA38F9-38BC-42BB-8537-4FC32FA12E7E}" type="slidenum">
              <a:rPr b="0" lang="en-US" sz="1200" spc="-1" strike="noStrike">
                <a:solidFill>
                  <a:srgbClr val="ffffff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굴림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1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Calibri"/>
              <a:ea typeface="맑은 고딕"/>
            </a:endParaRPr>
          </a:p>
        </p:txBody>
      </p:sp>
      <p:sp>
        <p:nvSpPr>
          <p:cNvPr id="215" name="슬라이드 번호 개체 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F4844A-4ACF-4741-B7DB-6B0DFC585823}" type="slidenum">
              <a:rPr b="0" lang="en-US" sz="1200" spc="-1" strike="noStrike">
                <a:solidFill>
                  <a:srgbClr val="ffffff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굴림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1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Calibri"/>
              <a:ea typeface="맑은 고딕"/>
            </a:endParaRPr>
          </a:p>
        </p:txBody>
      </p:sp>
      <p:sp>
        <p:nvSpPr>
          <p:cNvPr id="218" name="슬라이드 번호 개체 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ADADBF5-C161-46F3-BECE-83F50F6C219D}" type="slidenum">
              <a:rPr b="0" lang="en-US" sz="1200" spc="-1" strike="noStrike">
                <a:solidFill>
                  <a:srgbClr val="ffffff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굴림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2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Calibri"/>
              <a:ea typeface="맑은 고딕"/>
            </a:endParaRPr>
          </a:p>
        </p:txBody>
      </p:sp>
      <p:sp>
        <p:nvSpPr>
          <p:cNvPr id="221" name="슬라이드 번호 개체 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F1C9644-1D4F-4E75-A9E6-81959384067D}" type="slidenum">
              <a:rPr b="0" lang="en-US" sz="1200" spc="-1" strike="noStrike">
                <a:solidFill>
                  <a:srgbClr val="ffffff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굴림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2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Calibri"/>
              <a:ea typeface="맑은 고딕"/>
            </a:endParaRPr>
          </a:p>
        </p:txBody>
      </p:sp>
      <p:sp>
        <p:nvSpPr>
          <p:cNvPr id="224" name="슬라이드 번호 개체 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6E6064-5440-46DE-B8FA-9B3B1202E800}" type="slidenum">
              <a:rPr b="0" lang="en-US" sz="1200" spc="-1" strike="noStrike">
                <a:solidFill>
                  <a:srgbClr val="ffffff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굴림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2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Calibri"/>
              <a:ea typeface="맑은 고딕"/>
            </a:endParaRPr>
          </a:p>
        </p:txBody>
      </p:sp>
      <p:sp>
        <p:nvSpPr>
          <p:cNvPr id="227" name="슬라이드 번호 개체 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032EFA-988E-49D9-8BF7-9E1D2D0541DC}" type="slidenum">
              <a:rPr b="0" lang="en-US" sz="1200" spc="-1" strike="noStrike">
                <a:solidFill>
                  <a:srgbClr val="ffffff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굴림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3ECEA5-506F-465F-8AE6-E44FB60E1FD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533520" y="1828800"/>
            <a:ext cx="815328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533520" y="3938040"/>
            <a:ext cx="815328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C7CCA8-FE5A-42AB-8333-2E2C1E842C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4" name="PlaceHolder 2"/>
          <p:cNvSpPr>
            <a:spLocks noGrp="1"/>
          </p:cNvSpPr>
          <p:nvPr>
            <p:ph/>
          </p:nvPr>
        </p:nvSpPr>
        <p:spPr>
          <a:xfrm>
            <a:off x="533520" y="182880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" name="PlaceHolder 3"/>
          <p:cNvSpPr>
            <a:spLocks noGrp="1"/>
          </p:cNvSpPr>
          <p:nvPr>
            <p:ph/>
          </p:nvPr>
        </p:nvSpPr>
        <p:spPr>
          <a:xfrm>
            <a:off x="4711680" y="182880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" name="PlaceHolder 4"/>
          <p:cNvSpPr>
            <a:spLocks noGrp="1"/>
          </p:cNvSpPr>
          <p:nvPr>
            <p:ph/>
          </p:nvPr>
        </p:nvSpPr>
        <p:spPr>
          <a:xfrm>
            <a:off x="533520" y="393804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" name="PlaceHolder 5"/>
          <p:cNvSpPr>
            <a:spLocks noGrp="1"/>
          </p:cNvSpPr>
          <p:nvPr>
            <p:ph/>
          </p:nvPr>
        </p:nvSpPr>
        <p:spPr>
          <a:xfrm>
            <a:off x="4711680" y="393804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B258D3-C1C0-4C2B-B711-BD25F8F47BB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/>
          </p:nvPr>
        </p:nvSpPr>
        <p:spPr>
          <a:xfrm>
            <a:off x="533520" y="1828800"/>
            <a:ext cx="26251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" name="PlaceHolder 3"/>
          <p:cNvSpPr>
            <a:spLocks noGrp="1"/>
          </p:cNvSpPr>
          <p:nvPr>
            <p:ph/>
          </p:nvPr>
        </p:nvSpPr>
        <p:spPr>
          <a:xfrm>
            <a:off x="3290400" y="1828800"/>
            <a:ext cx="26251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" name="PlaceHolder 4"/>
          <p:cNvSpPr>
            <a:spLocks noGrp="1"/>
          </p:cNvSpPr>
          <p:nvPr>
            <p:ph/>
          </p:nvPr>
        </p:nvSpPr>
        <p:spPr>
          <a:xfrm>
            <a:off x="6046920" y="1828800"/>
            <a:ext cx="26251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" name="PlaceHolder 5"/>
          <p:cNvSpPr>
            <a:spLocks noGrp="1"/>
          </p:cNvSpPr>
          <p:nvPr>
            <p:ph/>
          </p:nvPr>
        </p:nvSpPr>
        <p:spPr>
          <a:xfrm>
            <a:off x="533520" y="3938040"/>
            <a:ext cx="26251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" name="PlaceHolder 6"/>
          <p:cNvSpPr>
            <a:spLocks noGrp="1"/>
          </p:cNvSpPr>
          <p:nvPr>
            <p:ph/>
          </p:nvPr>
        </p:nvSpPr>
        <p:spPr>
          <a:xfrm>
            <a:off x="3290400" y="3938040"/>
            <a:ext cx="26251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" name="PlaceHolder 7"/>
          <p:cNvSpPr>
            <a:spLocks noGrp="1"/>
          </p:cNvSpPr>
          <p:nvPr>
            <p:ph/>
          </p:nvPr>
        </p:nvSpPr>
        <p:spPr>
          <a:xfrm>
            <a:off x="6046920" y="3938040"/>
            <a:ext cx="26251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14B2FE-B0D4-4AD8-A9EA-BB039FBA71A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E7FD851-8011-4558-9338-EF00BEE7EE2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5" name="PlaceHolder 2"/>
          <p:cNvSpPr>
            <a:spLocks noGrp="1"/>
          </p:cNvSpPr>
          <p:nvPr>
            <p:ph type="subTitle"/>
          </p:nvPr>
        </p:nvSpPr>
        <p:spPr>
          <a:xfrm>
            <a:off x="533520" y="1828800"/>
            <a:ext cx="8153280" cy="4038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7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E96DC34-8CBA-412D-86C5-D60FEA8DE4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/>
          </p:nvPr>
        </p:nvSpPr>
        <p:spPr>
          <a:xfrm>
            <a:off x="533520" y="1828800"/>
            <a:ext cx="8153280" cy="40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F064970-281B-410E-98DC-3486891F7F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9" name="PlaceHolder 2"/>
          <p:cNvSpPr>
            <a:spLocks noGrp="1"/>
          </p:cNvSpPr>
          <p:nvPr>
            <p:ph/>
          </p:nvPr>
        </p:nvSpPr>
        <p:spPr>
          <a:xfrm>
            <a:off x="533520" y="1828800"/>
            <a:ext cx="3978720" cy="40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0" name="PlaceHolder 3"/>
          <p:cNvSpPr>
            <a:spLocks noGrp="1"/>
          </p:cNvSpPr>
          <p:nvPr>
            <p:ph/>
          </p:nvPr>
        </p:nvSpPr>
        <p:spPr>
          <a:xfrm>
            <a:off x="4711680" y="1828800"/>
            <a:ext cx="3978720" cy="40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26AEEEB-9908-4DCD-8F0E-3F211A0259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A233ED2-89DA-4AF8-A927-B14DE749FC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subTitle"/>
          </p:nvPr>
        </p:nvSpPr>
        <p:spPr>
          <a:xfrm>
            <a:off x="533520" y="472680"/>
            <a:ext cx="815328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35134EE-D584-442B-AD74-0B2BFE7773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533520" y="182880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711680" y="1828800"/>
            <a:ext cx="3978720" cy="40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533520" y="393804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48B3E5B-770D-4650-876D-1D984EA502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subTitle"/>
          </p:nvPr>
        </p:nvSpPr>
        <p:spPr>
          <a:xfrm>
            <a:off x="533520" y="1828800"/>
            <a:ext cx="8153280" cy="4038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7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A05A99-AD83-4645-8A55-EDF417E879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533520" y="1828800"/>
            <a:ext cx="3978720" cy="40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711680" y="182880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0" name="PlaceHolder 4"/>
          <p:cNvSpPr>
            <a:spLocks noGrp="1"/>
          </p:cNvSpPr>
          <p:nvPr>
            <p:ph/>
          </p:nvPr>
        </p:nvSpPr>
        <p:spPr>
          <a:xfrm>
            <a:off x="4711680" y="393804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26D8E68-2264-4653-B809-A6F320B231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533520" y="182880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/>
          </p:nvPr>
        </p:nvSpPr>
        <p:spPr>
          <a:xfrm>
            <a:off x="4711680" y="182880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/>
          </p:nvPr>
        </p:nvSpPr>
        <p:spPr>
          <a:xfrm>
            <a:off x="533520" y="3938040"/>
            <a:ext cx="815328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79DFFA1-062C-4461-B856-D6AC60079D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533520" y="1828800"/>
            <a:ext cx="815328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533520" y="3938040"/>
            <a:ext cx="815328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5B070E6-8FF5-461B-9CFC-7BBC2C546F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9" name="PlaceHolder 2"/>
          <p:cNvSpPr>
            <a:spLocks noGrp="1"/>
          </p:cNvSpPr>
          <p:nvPr>
            <p:ph/>
          </p:nvPr>
        </p:nvSpPr>
        <p:spPr>
          <a:xfrm>
            <a:off x="533520" y="182880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0" name="PlaceHolder 3"/>
          <p:cNvSpPr>
            <a:spLocks noGrp="1"/>
          </p:cNvSpPr>
          <p:nvPr>
            <p:ph/>
          </p:nvPr>
        </p:nvSpPr>
        <p:spPr>
          <a:xfrm>
            <a:off x="4711680" y="182880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1" name="PlaceHolder 4"/>
          <p:cNvSpPr>
            <a:spLocks noGrp="1"/>
          </p:cNvSpPr>
          <p:nvPr>
            <p:ph/>
          </p:nvPr>
        </p:nvSpPr>
        <p:spPr>
          <a:xfrm>
            <a:off x="533520" y="393804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2" name="PlaceHolder 5"/>
          <p:cNvSpPr>
            <a:spLocks noGrp="1"/>
          </p:cNvSpPr>
          <p:nvPr>
            <p:ph/>
          </p:nvPr>
        </p:nvSpPr>
        <p:spPr>
          <a:xfrm>
            <a:off x="4711680" y="393804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5C9C3DA-6E10-4281-AD8B-0D74004C9B6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/>
          </p:nvPr>
        </p:nvSpPr>
        <p:spPr>
          <a:xfrm>
            <a:off x="533520" y="1828800"/>
            <a:ext cx="26251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5" name="PlaceHolder 3"/>
          <p:cNvSpPr>
            <a:spLocks noGrp="1"/>
          </p:cNvSpPr>
          <p:nvPr>
            <p:ph/>
          </p:nvPr>
        </p:nvSpPr>
        <p:spPr>
          <a:xfrm>
            <a:off x="3290400" y="1828800"/>
            <a:ext cx="26251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6" name="PlaceHolder 4"/>
          <p:cNvSpPr>
            <a:spLocks noGrp="1"/>
          </p:cNvSpPr>
          <p:nvPr>
            <p:ph/>
          </p:nvPr>
        </p:nvSpPr>
        <p:spPr>
          <a:xfrm>
            <a:off x="6046920" y="1828800"/>
            <a:ext cx="26251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7" name="PlaceHolder 5"/>
          <p:cNvSpPr>
            <a:spLocks noGrp="1"/>
          </p:cNvSpPr>
          <p:nvPr>
            <p:ph/>
          </p:nvPr>
        </p:nvSpPr>
        <p:spPr>
          <a:xfrm>
            <a:off x="533520" y="3938040"/>
            <a:ext cx="26251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8" name="PlaceHolder 6"/>
          <p:cNvSpPr>
            <a:spLocks noGrp="1"/>
          </p:cNvSpPr>
          <p:nvPr>
            <p:ph/>
          </p:nvPr>
        </p:nvSpPr>
        <p:spPr>
          <a:xfrm>
            <a:off x="3290400" y="3938040"/>
            <a:ext cx="26251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9" name="PlaceHolder 7"/>
          <p:cNvSpPr>
            <a:spLocks noGrp="1"/>
          </p:cNvSpPr>
          <p:nvPr>
            <p:ph/>
          </p:nvPr>
        </p:nvSpPr>
        <p:spPr>
          <a:xfrm>
            <a:off x="6046920" y="3938040"/>
            <a:ext cx="26251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79560BF-564D-4B62-9EAD-C8E4D9651CB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533520" y="1828800"/>
            <a:ext cx="8153280" cy="40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37D3D4-5F57-4ABF-B60C-12691D6F76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533520" y="1828800"/>
            <a:ext cx="3978720" cy="40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/>
          </p:nvPr>
        </p:nvSpPr>
        <p:spPr>
          <a:xfrm>
            <a:off x="4711680" y="1828800"/>
            <a:ext cx="3978720" cy="40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BCAD0A-68E6-48FA-B8A3-ABB96077C1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A5CEDD-38F5-44F9-86FC-376DA4CBCF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subTitle"/>
          </p:nvPr>
        </p:nvSpPr>
        <p:spPr>
          <a:xfrm>
            <a:off x="533520" y="472680"/>
            <a:ext cx="815328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5FC2A9-99A4-4853-AD69-65F039E7B7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33520" y="182880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711680" y="1828800"/>
            <a:ext cx="3978720" cy="40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33520" y="393804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3895B0-5CF3-4A55-B2CB-F3F6EC3B70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33520" y="1828800"/>
            <a:ext cx="3978720" cy="40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711680" y="182880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1680" y="393804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FF52BD-B6BE-40D0-859B-00AADDE517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33520" y="182880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1680" y="1828800"/>
            <a:ext cx="397872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533520" y="3938040"/>
            <a:ext cx="8153280" cy="192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74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8CE1AE-575F-475A-9793-812ACAFCD2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0" name="Group 2"/>
          <p:cNvGrpSpPr/>
          <p:nvPr/>
        </p:nvGrpSpPr>
        <p:grpSpPr>
          <a:xfrm>
            <a:off x="228600" y="228600"/>
            <a:ext cx="8686800" cy="5943600"/>
            <a:chOff x="228600" y="228600"/>
            <a:chExt cx="8686800" cy="5943600"/>
          </a:xfrm>
        </p:grpSpPr>
        <p:sp>
          <p:nvSpPr>
            <p:cNvPr id="1" name="Rectangle 3"/>
            <p:cNvSpPr/>
            <p:nvPr/>
          </p:nvSpPr>
          <p:spPr>
            <a:xfrm>
              <a:off x="228600" y="228600"/>
              <a:ext cx="8686800" cy="5943600"/>
            </a:xfrm>
            <a:prstGeom prst="rect">
              <a:avLst/>
            </a:prstGeom>
            <a:solidFill>
              <a:srgbClr val="000000"/>
            </a:solidFill>
            <a:ln w="442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굴림"/>
              </a:endParaRPr>
            </a:p>
          </p:txBody>
        </p:sp>
        <p:sp>
          <p:nvSpPr>
            <p:cNvPr id="2" name="Rectangle 4"/>
            <p:cNvSpPr/>
            <p:nvPr/>
          </p:nvSpPr>
          <p:spPr>
            <a:xfrm>
              <a:off x="306360" y="306360"/>
              <a:ext cx="8529840" cy="57704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굴림"/>
              </a:endParaRPr>
            </a:p>
          </p:txBody>
        </p:sp>
        <p:sp>
          <p:nvSpPr>
            <p:cNvPr id="3" name="Line 5"/>
            <p:cNvSpPr/>
            <p:nvPr/>
          </p:nvSpPr>
          <p:spPr>
            <a:xfrm>
              <a:off x="533520" y="1733400"/>
              <a:ext cx="8153280" cy="0"/>
            </a:xfrm>
            <a:prstGeom prst="line">
              <a:avLst/>
            </a:prstGeom>
            <a:ln w="1260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굴림"/>
              </a:endParaRPr>
            </a:p>
          </p:txBody>
        </p:sp>
      </p:grpSp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ffffff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533520" y="1828800"/>
            <a:ext cx="8153280" cy="40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74"/>
              </a:spcBef>
              <a:buClr>
                <a:srgbClr val="99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spcBef>
                <a:spcPts val="774"/>
              </a:spcBef>
              <a:buClr>
                <a:srgbClr val="666699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  <a:p>
            <a:pPr lvl="2" marL="1143000" indent="-228600">
              <a:spcBef>
                <a:spcPts val="774"/>
              </a:spcBef>
              <a:buClr>
                <a:srgbClr val="9999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  <a:p>
            <a:pPr lvl="3" marL="1600200" indent="-228600">
              <a:spcBef>
                <a:spcPts val="774"/>
              </a:spcBef>
              <a:buClr>
                <a:srgbClr val="99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  <a:p>
            <a:pPr lvl="4" marL="2057400" indent="-228600">
              <a:spcBef>
                <a:spcPts val="774"/>
              </a:spcBef>
              <a:buClr>
                <a:srgbClr val="ffffff"/>
              </a:buClr>
              <a:buSzPct val="8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  <a:p>
            <a:pPr lvl="5" marL="2057400" indent="-228600">
              <a:spcBef>
                <a:spcPts val="774"/>
              </a:spcBef>
              <a:buClr>
                <a:srgbClr val="ffffff"/>
              </a:buClr>
              <a:buSzPct val="8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  <a:p>
            <a:pPr lvl="6" marL="2057400" indent="-228600">
              <a:spcBef>
                <a:spcPts val="774"/>
              </a:spcBef>
              <a:buClr>
                <a:srgbClr val="ffffff"/>
              </a:buClr>
              <a:buSzPct val="8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" name="PlaceHolder 3"/>
          <p:cNvSpPr>
            <a:spLocks noGrp="1"/>
          </p:cNvSpPr>
          <p:nvPr>
            <p:ph type="dt" idx="1"/>
          </p:nvPr>
        </p:nvSpPr>
        <p:spPr>
          <a:xfrm>
            <a:off x="533160" y="6248520"/>
            <a:ext cx="20574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F2BBA2-815F-420D-B7FC-2428477D71F4}" type="datetime">
              <a:rPr b="0" lang="en-US" sz="1000" spc="-1" strike="noStrike">
                <a:solidFill>
                  <a:srgbClr val="ffffff"/>
                </a:solidFill>
                <a:latin typeface="Arial"/>
              </a:rPr>
              <a:t>08/29/26</a:t>
            </a:fld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" name="PlaceHolder 4"/>
          <p:cNvSpPr>
            <a:spLocks noGrp="1"/>
          </p:cNvSpPr>
          <p:nvPr>
            <p:ph type="ftr" idx="2"/>
          </p:nvPr>
        </p:nvSpPr>
        <p:spPr>
          <a:xfrm>
            <a:off x="3238200" y="6248520"/>
            <a:ext cx="28954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8" name="PlaceHolder 5"/>
          <p:cNvSpPr>
            <a:spLocks noGrp="1"/>
          </p:cNvSpPr>
          <p:nvPr>
            <p:ph type="sldNum" idx="3"/>
          </p:nvPr>
        </p:nvSpPr>
        <p:spPr>
          <a:xfrm>
            <a:off x="67816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0D24351-72B1-4305-8FC8-7AFE63E0376C}" type="slidenum">
              <a:rPr b="0" lang="en-US" sz="10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Group 2"/>
          <p:cNvGrpSpPr/>
          <p:nvPr/>
        </p:nvGrpSpPr>
        <p:grpSpPr>
          <a:xfrm>
            <a:off x="380880" y="457200"/>
            <a:ext cx="8398080" cy="5562720"/>
            <a:chOff x="380880" y="457200"/>
            <a:chExt cx="8398080" cy="5562720"/>
          </a:xfrm>
        </p:grpSpPr>
        <p:sp>
          <p:nvSpPr>
            <p:cNvPr id="46" name="Rectangle 3"/>
            <p:cNvSpPr/>
            <p:nvPr/>
          </p:nvSpPr>
          <p:spPr>
            <a:xfrm>
              <a:off x="380880" y="457200"/>
              <a:ext cx="8398080" cy="5562720"/>
            </a:xfrm>
            <a:prstGeom prst="rect">
              <a:avLst/>
            </a:prstGeom>
            <a:solidFill>
              <a:srgbClr val="000000"/>
            </a:solidFill>
            <a:ln w="507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굴림"/>
              </a:endParaRPr>
            </a:p>
          </p:txBody>
        </p:sp>
        <p:sp>
          <p:nvSpPr>
            <p:cNvPr id="47" name="Rectangle 4"/>
            <p:cNvSpPr/>
            <p:nvPr/>
          </p:nvSpPr>
          <p:spPr>
            <a:xfrm>
              <a:off x="452520" y="533520"/>
              <a:ext cx="8229600" cy="541008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굴림"/>
              </a:endParaRPr>
            </a:p>
          </p:txBody>
        </p:sp>
        <p:sp>
          <p:nvSpPr>
            <p:cNvPr id="48" name="Line 5"/>
            <p:cNvSpPr/>
            <p:nvPr/>
          </p:nvSpPr>
          <p:spPr>
            <a:xfrm>
              <a:off x="914400" y="3581280"/>
              <a:ext cx="7315200" cy="0"/>
            </a:xfrm>
            <a:prstGeom prst="line">
              <a:avLst/>
            </a:prstGeom>
            <a:ln w="19080">
              <a:solidFill>
                <a:srgbClr val="99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굴림"/>
              </a:endParaRPr>
            </a:p>
          </p:txBody>
        </p:sp>
      </p:grpSp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533520" y="47268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ffffff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 type="body"/>
          </p:nvPr>
        </p:nvSpPr>
        <p:spPr>
          <a:xfrm>
            <a:off x="533520" y="1828800"/>
            <a:ext cx="8153280" cy="403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74"/>
              </a:spcBef>
              <a:buClr>
                <a:srgbClr val="99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ffffff"/>
                </a:solidFill>
                <a:latin typeface="Arial"/>
              </a:rPr>
              <a:t>Click to edit the outline text format</a:t>
            </a: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  <a:p>
            <a:pPr lvl="1" marL="743040" indent="-285840">
              <a:spcBef>
                <a:spcPts val="774"/>
              </a:spcBef>
              <a:buClr>
                <a:srgbClr val="666699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ffffff"/>
                </a:solidFill>
                <a:latin typeface="Arial"/>
              </a:rPr>
              <a:t>Second Outline Level</a:t>
            </a: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  <a:p>
            <a:pPr lvl="2" marL="1143000" indent="-228600">
              <a:spcBef>
                <a:spcPts val="774"/>
              </a:spcBef>
              <a:buClr>
                <a:srgbClr val="999900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ffffff"/>
                </a:solidFill>
                <a:latin typeface="Arial"/>
              </a:rPr>
              <a:t>Third Outline Level</a:t>
            </a: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  <a:p>
            <a:pPr lvl="3" marL="1600200" indent="-228600">
              <a:spcBef>
                <a:spcPts val="774"/>
              </a:spcBef>
              <a:buClr>
                <a:srgbClr val="99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ffffff"/>
                </a:solidFill>
                <a:latin typeface="Arial"/>
              </a:rPr>
              <a:t>Fourth Outline Level</a:t>
            </a: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  <a:p>
            <a:pPr lvl="4" marL="2057400" indent="-228600">
              <a:spcBef>
                <a:spcPts val="774"/>
              </a:spcBef>
              <a:buClr>
                <a:srgbClr val="ffffff"/>
              </a:buClr>
              <a:buSzPct val="8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ffffff"/>
                </a:solidFill>
                <a:latin typeface="Arial"/>
              </a:rPr>
              <a:t>Fifth Outline Level</a:t>
            </a: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  <a:p>
            <a:pPr lvl="5" marL="2057400" indent="-228600">
              <a:spcBef>
                <a:spcPts val="774"/>
              </a:spcBef>
              <a:buClr>
                <a:srgbClr val="ffffff"/>
              </a:buClr>
              <a:buSzPct val="8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ffffff"/>
                </a:solidFill>
                <a:latin typeface="Arial"/>
              </a:rPr>
              <a:t>Sixth Outline Level</a:t>
            </a: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  <a:p>
            <a:pPr lvl="6" marL="2057400" indent="-228600">
              <a:spcBef>
                <a:spcPts val="774"/>
              </a:spcBef>
              <a:buClr>
                <a:srgbClr val="ffffff"/>
              </a:buClr>
              <a:buSzPct val="85000"/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100" spc="-1" strike="noStrike">
                <a:solidFill>
                  <a:srgbClr val="ffffff"/>
                </a:solidFill>
                <a:latin typeface="Arial"/>
              </a:rPr>
              <a:t>Seventh Outline Level</a:t>
            </a:r>
            <a:endParaRPr b="0" lang="en-US" sz="3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" name="PlaceHolder 3"/>
          <p:cNvSpPr>
            <a:spLocks noGrp="1"/>
          </p:cNvSpPr>
          <p:nvPr>
            <p:ph type="dt" idx="4"/>
          </p:nvPr>
        </p:nvSpPr>
        <p:spPr>
          <a:xfrm>
            <a:off x="536040" y="6248520"/>
            <a:ext cx="20545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D834D3-40D5-42C0-ACB0-E3D9ED9193A3}" type="datetime">
              <a:rPr b="0" lang="en-US" sz="1000" spc="-1" strike="noStrike">
                <a:solidFill>
                  <a:srgbClr val="ffffff"/>
                </a:solidFill>
                <a:latin typeface="Arial"/>
              </a:rPr>
              <a:t>08/29/26</a:t>
            </a:fld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2" name="PlaceHolder 4"/>
          <p:cNvSpPr>
            <a:spLocks noGrp="1"/>
          </p:cNvSpPr>
          <p:nvPr>
            <p:ph type="ftr" idx="5"/>
          </p:nvPr>
        </p:nvSpPr>
        <p:spPr>
          <a:xfrm>
            <a:off x="3250800" y="6248520"/>
            <a:ext cx="288756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53" name="PlaceHolder 5"/>
          <p:cNvSpPr>
            <a:spLocks noGrp="1"/>
          </p:cNvSpPr>
          <p:nvPr>
            <p:ph type="sldNum" idx="6"/>
          </p:nvPr>
        </p:nvSpPr>
        <p:spPr>
          <a:xfrm>
            <a:off x="6788160" y="625788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0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531540-5C76-4D7F-B7BC-9ADA0D75F82B}" type="slidenum">
              <a:rPr b="0" lang="en-US" sz="10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3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3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1219320" y="837720"/>
            <a:ext cx="6781680" cy="2559240"/>
          </a:xfrm>
          <a:prstGeom prst="rect">
            <a:avLst/>
          </a:prstGeom>
          <a:noFill/>
          <a:ln w="0">
            <a:noFill/>
          </a:ln>
        </p:spPr>
        <p:txBody>
          <a:bodyPr anchor="b" anchorCtr="1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200" spc="-1" strike="noStrike">
                <a:solidFill>
                  <a:srgbClr val="ffff00"/>
                </a:solidFill>
                <a:latin typeface="Times New Roman"/>
                <a:ea typeface="굴림"/>
              </a:rPr>
              <a:t>Static slides demonstrating Split-Attention Effect</a:t>
            </a:r>
            <a:endParaRPr b="0" lang="en-US" sz="6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8" name="PlaceHolder 2"/>
          <p:cNvSpPr>
            <a:spLocks noGrp="1"/>
          </p:cNvSpPr>
          <p:nvPr>
            <p:ph type="subTitle"/>
          </p:nvPr>
        </p:nvSpPr>
        <p:spPr>
          <a:xfrm>
            <a:off x="914400" y="3505320"/>
            <a:ext cx="7391520" cy="2133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ctr">
              <a:lnSpc>
                <a:spcPct val="100000"/>
              </a:lnSpc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ffffff"/>
                </a:solidFill>
                <a:latin typeface="Times New Roman"/>
                <a:ea typeface="굴림"/>
              </a:rPr>
              <a:t>Conventional diagrams</a:t>
            </a:r>
            <a:endParaRPr b="0" lang="en-US" sz="3000" spc="-1" strike="noStrike">
              <a:solidFill>
                <a:srgbClr val="ffffff"/>
              </a:solidFill>
              <a:latin typeface="Arial"/>
            </a:endParaRPr>
          </a:p>
          <a:p>
            <a:pPr indent="0" algn="ctr">
              <a:lnSpc>
                <a:spcPct val="100000"/>
              </a:lnSpc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ffffff"/>
              </a:solidFill>
              <a:latin typeface="Arial"/>
            </a:endParaRPr>
          </a:p>
          <a:p>
            <a:pPr indent="0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굴림"/>
              </a:rPr>
              <a:t>Journal of Educational Evaluation for Health Professions. 2009 Dec;6:6.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  <a:p>
            <a:pPr indent="0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doi: 10.3352/jeehp.2009.6.6. 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  <a:p>
            <a:pPr indent="0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굴림"/>
              </a:rPr>
              <a:t>Copyright © 2009, National Health Personnel Licensing Examination Board of the Republic of Korea 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  <a:p>
            <a:pPr indent="0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굴림"/>
              </a:rPr>
              <a:t>This is an open-access article distributed under the terms of the Creative Commons Attribution License, which permits unrestricted use, distribution, and reproduction in any medium, provided the original work is properly cited.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  <a:p>
            <a:pPr indent="0" algn="ctr">
              <a:lnSpc>
                <a:spcPct val="100000"/>
              </a:lnSpc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ffffff"/>
              </a:solidFill>
              <a:latin typeface="Arial"/>
            </a:endParaRPr>
          </a:p>
          <a:p>
            <a:pPr indent="0" algn="ctr">
              <a:lnSpc>
                <a:spcPct val="100000"/>
              </a:lnSpc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ffffff"/>
              </a:solidFill>
              <a:latin typeface="Arial"/>
            </a:endParaRPr>
          </a:p>
          <a:p>
            <a:pPr indent="0" algn="ctr">
              <a:lnSpc>
                <a:spcPct val="100000"/>
              </a:lnSpc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ffffff"/>
              </a:solidFill>
              <a:latin typeface="Arial"/>
            </a:endParaRPr>
          </a:p>
          <a:p>
            <a:pPr indent="0" algn="ctr">
              <a:lnSpc>
                <a:spcPct val="100000"/>
              </a:lnSpc>
              <a:spcBef>
                <a:spcPts val="7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9" name="Slide Number Placeholder 3"/>
          <p:cNvSpPr/>
          <p:nvPr/>
        </p:nvSpPr>
        <p:spPr>
          <a:xfrm>
            <a:off x="6788160" y="6257880"/>
            <a:ext cx="19051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2DB9479-8779-46C4-9058-D3B359AF688D}" type="slidenum">
              <a:rPr b="0" lang="en-US" sz="10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ffffff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990720" y="137124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4400" spc="-1" strike="noStrike">
                <a:solidFill>
                  <a:srgbClr val="ffffff"/>
                </a:solidFill>
                <a:latin typeface="Times New Roman"/>
                <a:ea typeface="굴림"/>
              </a:rPr>
              <a:t>ACID-BASE BALANCE THROUGH INORGANIC ACID EXCHANGE</a:t>
            </a:r>
            <a:br>
              <a:rPr sz="4400"/>
            </a:b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pic>
        <p:nvPicPr>
          <p:cNvPr id="101" name="Content Placeholder 3" descr="renal.jpg"/>
          <p:cNvPicPr/>
          <p:nvPr/>
        </p:nvPicPr>
        <p:blipFill>
          <a:blip r:embed="rId1"/>
          <a:stretch/>
        </p:blipFill>
        <p:spPr>
          <a:xfrm>
            <a:off x="1752480" y="2057400"/>
            <a:ext cx="5639040" cy="3429000"/>
          </a:xfrm>
          <a:prstGeom prst="rect">
            <a:avLst/>
          </a:prstGeom>
          <a:ln w="0">
            <a:noFill/>
          </a:ln>
        </p:spPr>
      </p:pic>
      <p:sp>
        <p:nvSpPr>
          <p:cNvPr id="102" name="Slide Number Placeholder 4"/>
          <p:cNvSpPr/>
          <p:nvPr/>
        </p:nvSpPr>
        <p:spPr>
          <a:xfrm>
            <a:off x="67816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EE8B2C-8357-408B-8E93-F60F4F2A71E6}" type="slidenum">
              <a:rPr b="0" lang="en-US" sz="10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ffffff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title"/>
          </p:nvPr>
        </p:nvSpPr>
        <p:spPr>
          <a:xfrm>
            <a:off x="533520" y="1447560"/>
            <a:ext cx="8153280" cy="114300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4400" spc="-1" strike="noStrike">
                <a:solidFill>
                  <a:srgbClr val="ffffff"/>
                </a:solidFill>
                <a:latin typeface="Times New Roman"/>
                <a:ea typeface="굴림"/>
              </a:rPr>
              <a:t>ACID - BASE BALANCE :REABSORPTION OF BICARBONATE ION</a:t>
            </a:r>
            <a:br>
              <a:rPr sz="4400"/>
            </a:b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  <p:pic>
        <p:nvPicPr>
          <p:cNvPr id="104" name="Content Placeholder 3" descr="renal 2.jpg"/>
          <p:cNvPicPr/>
          <p:nvPr/>
        </p:nvPicPr>
        <p:blipFill>
          <a:blip r:embed="rId1"/>
          <a:stretch/>
        </p:blipFill>
        <p:spPr>
          <a:xfrm>
            <a:off x="1523880" y="2238480"/>
            <a:ext cx="5486400" cy="3476520"/>
          </a:xfrm>
          <a:prstGeom prst="rect">
            <a:avLst/>
          </a:prstGeom>
          <a:ln w="0">
            <a:noFill/>
          </a:ln>
        </p:spPr>
      </p:pic>
      <p:sp>
        <p:nvSpPr>
          <p:cNvPr id="105" name="Slide Number Placeholder 4"/>
          <p:cNvSpPr/>
          <p:nvPr/>
        </p:nvSpPr>
        <p:spPr>
          <a:xfrm>
            <a:off x="67816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85FE7A-3B78-4A04-8387-70E0F0CDB6B0}" type="slidenum">
              <a:rPr b="0" lang="en-US" sz="10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ffffff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PlaceHolder 1"/>
          <p:cNvSpPr>
            <a:spLocks noGrp="1"/>
          </p:cNvSpPr>
          <p:nvPr>
            <p:ph type="title"/>
          </p:nvPr>
        </p:nvSpPr>
        <p:spPr>
          <a:xfrm>
            <a:off x="1219320" y="837720"/>
            <a:ext cx="6781680" cy="2559240"/>
          </a:xfrm>
          <a:prstGeom prst="rect">
            <a:avLst/>
          </a:prstGeom>
          <a:noFill/>
          <a:ln w="0">
            <a:noFill/>
          </a:ln>
        </p:spPr>
        <p:txBody>
          <a:bodyPr anchor="b" anchorCtr="1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200" spc="-1" strike="noStrike">
                <a:solidFill>
                  <a:srgbClr val="ffffff"/>
                </a:solidFill>
                <a:latin typeface="Arial Black"/>
                <a:ea typeface="굴림"/>
              </a:rPr>
              <a:t>Integrated Example</a:t>
            </a:r>
            <a:endParaRPr b="0" lang="en-US" sz="6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7" name="PlaceHolder 2"/>
          <p:cNvSpPr>
            <a:spLocks noGrp="1"/>
          </p:cNvSpPr>
          <p:nvPr>
            <p:ph type="subTitle"/>
          </p:nvPr>
        </p:nvSpPr>
        <p:spPr>
          <a:xfrm>
            <a:off x="761760" y="3733560"/>
            <a:ext cx="7543800" cy="18730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ctr">
              <a:lnSpc>
                <a:spcPct val="10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ffff00"/>
                </a:solidFill>
                <a:latin typeface="Arial Black"/>
                <a:ea typeface="굴림"/>
              </a:rPr>
              <a:t>(Animation -based Lecture)</a:t>
            </a:r>
            <a:endParaRPr b="0" lang="en-US" sz="3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8" name="Slide Number Placeholder 3"/>
          <p:cNvSpPr/>
          <p:nvPr/>
        </p:nvSpPr>
        <p:spPr>
          <a:xfrm>
            <a:off x="6788160" y="6257880"/>
            <a:ext cx="19051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D5C862-2CD0-4ABF-9403-67AA4C02C3E7}" type="slidenum">
              <a:rPr b="0" lang="en-US" sz="10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ffffff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304560" y="0"/>
            <a:ext cx="8381880" cy="2209680"/>
          </a:xfrm>
          <a:prstGeom prst="rect">
            <a:avLst/>
          </a:prstGeom>
          <a:noFill/>
          <a:ln w="0">
            <a:noFill/>
          </a:ln>
        </p:spPr>
        <p:txBody>
          <a:bodyPr anchor="b" anchorCtr="1">
            <a:noAutofit/>
          </a:bodyPr>
          <a:p>
            <a:pPr indent="0" algn="ctr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ffffff"/>
                </a:solidFill>
                <a:latin typeface="Arial Black"/>
                <a:ea typeface="굴림"/>
              </a:rPr>
              <a:t>Mechanism for Generating </a:t>
            </a:r>
            <a:r>
              <a:rPr b="0" lang="en-US" sz="3600" spc="-1" strike="noStrike">
                <a:solidFill>
                  <a:srgbClr val="00b050"/>
                </a:solidFill>
                <a:latin typeface="Arial Black"/>
                <a:ea typeface="굴림"/>
              </a:rPr>
              <a:t>“New” </a:t>
            </a:r>
            <a:r>
              <a:rPr b="0" lang="en-US" sz="3600" spc="-1" strike="noStrike">
                <a:solidFill>
                  <a:srgbClr val="ffffff"/>
                </a:solidFill>
                <a:latin typeface="Arial Black"/>
                <a:ea typeface="굴림"/>
              </a:rPr>
              <a:t>Bicarbonate Ions</a:t>
            </a:r>
            <a:endParaRPr b="0" lang="en-US" sz="36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0" name="PlaceHolder 2"/>
          <p:cNvSpPr>
            <a:spLocks noGrp="1"/>
          </p:cNvSpPr>
          <p:nvPr>
            <p:ph type="subTitle"/>
          </p:nvPr>
        </p:nvSpPr>
        <p:spPr>
          <a:xfrm>
            <a:off x="457200" y="2819520"/>
            <a:ext cx="8305920" cy="3200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ctr">
              <a:lnSpc>
                <a:spcPct val="10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100000"/>
              </a:lnSpc>
              <a:spcBef>
                <a:spcPts val="700"/>
              </a:spcBef>
              <a:buClr>
                <a:srgbClr val="990000"/>
              </a:buClr>
              <a:buSzPct val="75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00"/>
                </a:solidFill>
                <a:latin typeface="Arial Black"/>
                <a:ea typeface="굴림"/>
              </a:rPr>
              <a:t> </a:t>
            </a:r>
            <a:r>
              <a:rPr b="1" lang="en-US" sz="2800" spc="-1" strike="noStrike">
                <a:solidFill>
                  <a:srgbClr val="ffff00"/>
                </a:solidFill>
                <a:latin typeface="Arial Black"/>
                <a:ea typeface="굴림"/>
              </a:rPr>
              <a:t>Ammonia Buffer System 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  <a:p>
            <a:pPr indent="0" algn="ctr">
              <a:lnSpc>
                <a:spcPct val="10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Arial Black"/>
                <a:ea typeface="굴림"/>
              </a:rPr>
              <a:t>mops excess H+ &amp; generate  New </a:t>
            </a:r>
            <a:r>
              <a:rPr b="0" lang="en-US" sz="2400" spc="-1" strike="noStrike">
                <a:solidFill>
                  <a:srgbClr val="ffffff"/>
                </a:solidFill>
                <a:latin typeface="Arial Black"/>
                <a:ea typeface="굴림"/>
              </a:rPr>
              <a:t>HCO</a:t>
            </a:r>
            <a:r>
              <a:rPr b="0" lang="en-US" sz="2400" spc="-1" strike="noStrike" baseline="-25000">
                <a:solidFill>
                  <a:srgbClr val="ffffff"/>
                </a:solidFill>
                <a:latin typeface="Arial Black"/>
                <a:ea typeface="굴림"/>
              </a:rPr>
              <a:t>3</a:t>
            </a:r>
            <a:r>
              <a:rPr b="0" lang="en-US" sz="2400" spc="-1" strike="noStrike" baseline="30000">
                <a:solidFill>
                  <a:srgbClr val="ffffff"/>
                </a:solidFill>
                <a:latin typeface="Arial Black"/>
                <a:ea typeface="굴림"/>
              </a:rPr>
              <a:t>- </a:t>
            </a:r>
            <a:r>
              <a:rPr b="1" lang="en-US" sz="2400" spc="-1" strike="noStrike">
                <a:solidFill>
                  <a:srgbClr val="ffffff"/>
                </a:solidFill>
                <a:latin typeface="Arial Black"/>
                <a:ea typeface="굴림"/>
              </a:rPr>
              <a:t>(</a:t>
            </a:r>
            <a:r>
              <a:rPr b="1" lang="en-US" sz="2400" spc="-1" strike="noStrike">
                <a:solidFill>
                  <a:srgbClr val="00b050"/>
                </a:solidFill>
                <a:latin typeface="Arial Black"/>
                <a:ea typeface="굴림"/>
              </a:rPr>
              <a:t>Bicarbonate reclamation </a:t>
            </a:r>
            <a:r>
              <a:rPr b="1" lang="en-US" sz="2400" spc="-1" strike="noStrike">
                <a:solidFill>
                  <a:srgbClr val="ffffff"/>
                </a:solidFill>
                <a:latin typeface="Arial"/>
                <a:ea typeface="굴림"/>
              </a:rPr>
              <a:t>)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1" name="Slide Number Placeholder 3"/>
          <p:cNvSpPr/>
          <p:nvPr/>
        </p:nvSpPr>
        <p:spPr>
          <a:xfrm>
            <a:off x="6788160" y="6257880"/>
            <a:ext cx="19051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B894BFB-844A-41AE-8911-930875D2AEEE}" type="slidenum">
              <a:rPr b="0" lang="en-US" sz="10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ffffff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27">
                                  <p:stCondLst>
                                    <p:cond delay="0"/>
                                  </p:stCondLst>
                                  <p:iterate type="lt">
                                    <p:tmAbs val="40"/>
                                  </p:iterate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0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discrete" valueType="clr">
                                      <p:cBhvr additive="repl">
                                        <p:cTn id="7" dur="80"/>
                                        <p:tgtEl>
                                          <p:spTgt spid="110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color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rgb(0,0,-103)"/>
                                          </p:val>
                                        </p:tav>
                                        <p:tav tm="50000">
                                          <p:val>
                                            <p:strVal val="rgb(0,-103,-103)"/>
                                          </p:val>
                                        </p:tav>
                                      </p:tavLst>
                                    </p:anim>
                                    <p:anim calcmode="discrete" valueType="clr">
                                      <p:cBhvr additive="repl">
                                        <p:cTn id="8" dur="80"/>
                                        <p:tgtEl>
                                          <p:spTgt spid="110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fillcolor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rgb(0,0,-103)"/>
                                          </p:val>
                                        </p:tav>
                                        <p:tav tm="50000">
                                          <p:val>
                                            <p:strVal val="rgb(0,-103,-103)"/>
                                          </p:val>
                                        </p:tav>
                                      </p:tavLst>
                                    </p:anim>
                                    <p:set>
                                      <p:cBhvr>
                                        <p:cTn id="9" dur="80"/>
                                        <p:tgtEl>
                                          <p:spTgt spid="110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fill.type</p:attrName>
                                        </p:attrNameLst>
                                      </p:cBhvr>
                                      <p:to>
                                        <p:strVal val="solid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0" nodeType="withEffect" fill="hold" presetClass="entr" presetID="3" presetSubtype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0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linds(horizontal)" transition="in">
                                      <p:cBhvr additive="repl">
                                        <p:cTn id="12" dur="500"/>
                                        <p:tgtEl>
                                          <p:spTgt spid="110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152280" y="-360"/>
            <a:ext cx="8761680" cy="60948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Times New Roman"/>
                <a:ea typeface="굴림"/>
              </a:rPr>
              <a:t>ACIDIFICATION OF URINE BY EXCRETION OF AMMONIA</a:t>
            </a: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3" name="Slide Number Placeholder 2"/>
          <p:cNvSpPr/>
          <p:nvPr/>
        </p:nvSpPr>
        <p:spPr>
          <a:xfrm>
            <a:off x="67816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C1278A-7433-491E-BB8C-7840FFB12C83}" type="slidenum">
              <a:rPr b="0" lang="en-US" sz="10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14" name="AutoShape 4"/>
          <p:cNvSpPr/>
          <p:nvPr/>
        </p:nvSpPr>
        <p:spPr>
          <a:xfrm>
            <a:off x="228600" y="762120"/>
            <a:ext cx="2209680" cy="6095880"/>
          </a:xfrm>
          <a:prstGeom prst="can">
            <a:avLst>
              <a:gd name="adj" fmla="val 7398"/>
            </a:avLst>
          </a:prstGeom>
          <a:solidFill>
            <a:srgbClr val="ff4d23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15" name="AutoShape 5"/>
          <p:cNvSpPr/>
          <p:nvPr/>
        </p:nvSpPr>
        <p:spPr>
          <a:xfrm>
            <a:off x="4876920" y="762120"/>
            <a:ext cx="2514600" cy="6400800"/>
          </a:xfrm>
          <a:prstGeom prst="can">
            <a:avLst>
              <a:gd name="adj" fmla="val 7398"/>
            </a:avLst>
          </a:prstGeom>
          <a:solidFill>
            <a:srgbClr val="ff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16" name="AutoShape 6"/>
          <p:cNvSpPr/>
          <p:nvPr/>
        </p:nvSpPr>
        <p:spPr>
          <a:xfrm>
            <a:off x="2666880" y="304920"/>
            <a:ext cx="2514600" cy="2286000"/>
          </a:xfrm>
          <a:prstGeom prst="roundRect">
            <a:avLst>
              <a:gd name="adj" fmla="val 16667"/>
            </a:avLst>
          </a:prstGeom>
          <a:solidFill>
            <a:srgbClr val="66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17" name="AutoShape 7"/>
          <p:cNvSpPr/>
          <p:nvPr/>
        </p:nvSpPr>
        <p:spPr>
          <a:xfrm>
            <a:off x="2666880" y="2590920"/>
            <a:ext cx="2514600" cy="2286000"/>
          </a:xfrm>
          <a:prstGeom prst="roundRect">
            <a:avLst>
              <a:gd name="adj" fmla="val 16667"/>
            </a:avLst>
          </a:prstGeom>
          <a:solidFill>
            <a:srgbClr val="66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18" name="AutoShape 8"/>
          <p:cNvSpPr/>
          <p:nvPr/>
        </p:nvSpPr>
        <p:spPr>
          <a:xfrm>
            <a:off x="2666880" y="4876920"/>
            <a:ext cx="2514600" cy="2286000"/>
          </a:xfrm>
          <a:prstGeom prst="roundRect">
            <a:avLst>
              <a:gd name="adj" fmla="val 16667"/>
            </a:avLst>
          </a:prstGeom>
          <a:solidFill>
            <a:srgbClr val="66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19" name="AutoShape 9"/>
          <p:cNvSpPr/>
          <p:nvPr/>
        </p:nvSpPr>
        <p:spPr>
          <a:xfrm>
            <a:off x="7086600" y="304920"/>
            <a:ext cx="2514600" cy="2286000"/>
          </a:xfrm>
          <a:prstGeom prst="roundRect">
            <a:avLst>
              <a:gd name="adj" fmla="val 16667"/>
            </a:avLst>
          </a:prstGeom>
          <a:solidFill>
            <a:srgbClr val="66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20" name="AutoShape 10"/>
          <p:cNvSpPr/>
          <p:nvPr/>
        </p:nvSpPr>
        <p:spPr>
          <a:xfrm>
            <a:off x="7086600" y="2590920"/>
            <a:ext cx="2514600" cy="2286000"/>
          </a:xfrm>
          <a:prstGeom prst="roundRect">
            <a:avLst>
              <a:gd name="adj" fmla="val 16667"/>
            </a:avLst>
          </a:prstGeom>
          <a:solidFill>
            <a:srgbClr val="66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21" name="AutoShape 11"/>
          <p:cNvSpPr/>
          <p:nvPr/>
        </p:nvSpPr>
        <p:spPr>
          <a:xfrm>
            <a:off x="7086600" y="4876920"/>
            <a:ext cx="2514600" cy="2286000"/>
          </a:xfrm>
          <a:prstGeom prst="roundRect">
            <a:avLst>
              <a:gd name="adj" fmla="val 16667"/>
            </a:avLst>
          </a:prstGeom>
          <a:solidFill>
            <a:srgbClr val="66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22" name="Rectangle 13"/>
          <p:cNvSpPr/>
          <p:nvPr/>
        </p:nvSpPr>
        <p:spPr>
          <a:xfrm>
            <a:off x="0" y="0"/>
            <a:ext cx="9448920" cy="609480"/>
          </a:xfrm>
          <a:prstGeom prst="rect">
            <a:avLst/>
          </a:prstGeom>
          <a:solidFill>
            <a:srgbClr val="2b2b8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23" name="Text Box 15"/>
          <p:cNvSpPr/>
          <p:nvPr/>
        </p:nvSpPr>
        <p:spPr>
          <a:xfrm>
            <a:off x="685800" y="746280"/>
            <a:ext cx="144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00"/>
                </a:solidFill>
                <a:latin typeface="Arial"/>
              </a:rPr>
              <a:t>Capillary</a:t>
            </a: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24" name="Text Box 16"/>
          <p:cNvSpPr/>
          <p:nvPr/>
        </p:nvSpPr>
        <p:spPr>
          <a:xfrm>
            <a:off x="2666880" y="685800"/>
            <a:ext cx="2514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666666"/>
                </a:solidFill>
                <a:latin typeface="Arial"/>
              </a:rPr>
              <a:t>Distal Tubule Cells</a:t>
            </a: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25" name="Text Box 18"/>
          <p:cNvSpPr/>
          <p:nvPr/>
        </p:nvSpPr>
        <p:spPr>
          <a:xfrm>
            <a:off x="5181480" y="5318280"/>
            <a:ext cx="1905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70c0"/>
                </a:solidFill>
                <a:latin typeface="Arial"/>
              </a:rPr>
              <a:t>Tubular urine to be excreted</a:t>
            </a: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26" name="Text Box 19"/>
          <p:cNvSpPr/>
          <p:nvPr/>
        </p:nvSpPr>
        <p:spPr>
          <a:xfrm>
            <a:off x="304920" y="1219320"/>
            <a:ext cx="990360" cy="57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66ff"/>
                </a:solidFill>
                <a:latin typeface="Arial"/>
              </a:rPr>
              <a:t>NH</a:t>
            </a:r>
            <a:r>
              <a:rPr b="0" lang="en-US" sz="2800" spc="-1" strike="noStrike" baseline="-25000">
                <a:solidFill>
                  <a:srgbClr val="0066ff"/>
                </a:solidFill>
                <a:latin typeface="Arial"/>
              </a:rPr>
              <a:t>2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27" name="Text Box 25"/>
          <p:cNvSpPr/>
          <p:nvPr/>
        </p:nvSpPr>
        <p:spPr>
          <a:xfrm>
            <a:off x="4419720" y="2666880"/>
            <a:ext cx="6094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H</a:t>
            </a:r>
            <a:r>
              <a:rPr b="0" lang="en-US" sz="2800" spc="-1" strike="noStrike" baseline="30000">
                <a:solidFill>
                  <a:srgbClr val="ffffff"/>
                </a:solidFill>
                <a:latin typeface="Arial"/>
              </a:rPr>
              <a:t>+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28" name="Text Box 29"/>
          <p:cNvSpPr/>
          <p:nvPr/>
        </p:nvSpPr>
        <p:spPr>
          <a:xfrm>
            <a:off x="3048120" y="2743200"/>
            <a:ext cx="990360" cy="57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0066"/>
                </a:solidFill>
                <a:latin typeface="Arial"/>
              </a:rPr>
              <a:t>NH</a:t>
            </a:r>
            <a:r>
              <a:rPr b="0" lang="en-US" sz="2800" spc="-1" strike="noStrike" baseline="-25000">
                <a:solidFill>
                  <a:srgbClr val="ff0066"/>
                </a:solidFill>
                <a:latin typeface="Arial"/>
              </a:rPr>
              <a:t>3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29" name="Text Box 43"/>
          <p:cNvSpPr/>
          <p:nvPr/>
        </p:nvSpPr>
        <p:spPr>
          <a:xfrm>
            <a:off x="304920" y="1219320"/>
            <a:ext cx="990360" cy="57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66ff"/>
                </a:solidFill>
                <a:latin typeface="Arial"/>
              </a:rPr>
              <a:t>NH</a:t>
            </a:r>
            <a:r>
              <a:rPr b="0" lang="en-US" sz="2800" spc="-1" strike="noStrike" baseline="-25000">
                <a:solidFill>
                  <a:srgbClr val="0066ff"/>
                </a:solidFill>
                <a:latin typeface="Arial"/>
              </a:rPr>
              <a:t>2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30" name="Text Box 44"/>
          <p:cNvSpPr/>
          <p:nvPr/>
        </p:nvSpPr>
        <p:spPr>
          <a:xfrm>
            <a:off x="4419720" y="2666880"/>
            <a:ext cx="6094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0000"/>
                </a:solidFill>
                <a:latin typeface="Arial"/>
              </a:rPr>
              <a:t>H</a:t>
            </a:r>
            <a:r>
              <a:rPr b="0" lang="en-US" sz="2800" spc="-1" strike="noStrike" baseline="30000">
                <a:solidFill>
                  <a:srgbClr val="ff0000"/>
                </a:solidFill>
                <a:latin typeface="Arial"/>
              </a:rPr>
              <a:t>+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31" name="Text Box 45"/>
          <p:cNvSpPr/>
          <p:nvPr/>
        </p:nvSpPr>
        <p:spPr>
          <a:xfrm>
            <a:off x="2895480" y="2743200"/>
            <a:ext cx="990720" cy="57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0066"/>
                </a:solidFill>
                <a:latin typeface="Arial"/>
              </a:rPr>
              <a:t>NH</a:t>
            </a:r>
            <a:r>
              <a:rPr b="0" lang="en-US" sz="2800" spc="-1" strike="noStrike" baseline="-25000">
                <a:solidFill>
                  <a:srgbClr val="ff0066"/>
                </a:solidFill>
                <a:latin typeface="Arial"/>
              </a:rPr>
              <a:t>3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32" name="Text Box 46"/>
          <p:cNvSpPr/>
          <p:nvPr/>
        </p:nvSpPr>
        <p:spPr>
          <a:xfrm>
            <a:off x="4572000" y="3200400"/>
            <a:ext cx="3048120" cy="1312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2060"/>
                </a:solidFill>
                <a:latin typeface="Arial"/>
              </a:rPr>
              <a:t>WHAT NEXT?</a:t>
            </a:r>
            <a:endParaRPr b="0" lang="en-US" sz="4000" spc="-1" strike="noStrike">
              <a:solidFill>
                <a:srgbClr val="ffffff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3" dur="indefinite" restart="never" nodeType="tmRoot">
          <p:childTnLst>
            <p:seq>
              <p:cTn id="14" dur="indefinite" nodeType="mainSeq"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0 C 0.00208 0.04699 0.00417 0.09398 0.01007 0.13333 C 0.01597 0.17268 0.01632 0.22037 0.03507 0.23657 C 0.05382 0.25277 0.0974 0.2324 0.12257 0.23009 C 0.14757 0.22777 0.15799 0.22453 0.18507 0.22338 C 0.21215 0.22222 0.24844 0.22268 0.28507 0.22338 E">
                                      <p:cBhvr>
                                        <p:cTn id="18" dur="3000" fill="hold"/>
                                        <p:tgtEl>
                                          <p:spTgt spid="126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9" fill="hold">
                            <p:stCondLst>
                              <p:cond delay="3000"/>
                            </p:stCondLst>
                            <p:childTnLst>
                              <p:par>
                                <p:cTn id="20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87 0.00716 C -0.01007 0.01341 -0.03507 0.04462 -0.05643 0.04532 C -0.07778 0.04601 -0.11424 0.01873 -0.12934 0.01156 E">
                                      <p:cBhvr>
                                        <p:cTn id="21" dur="2000" fill="hold"/>
                                        <p:tgtEl>
                                          <p:spTgt spid="127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2" fill="hold">
                            <p:stCondLst>
                              <p:cond delay="5000"/>
                            </p:stCondLst>
                            <p:childTnLst>
                              <p:par>
                                <p:cTn id="23" nodeType="afterEffect" fill="hold" presetClass="exit" presetID="1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24" dur="2000"/>
                                        <p:tgtEl>
                                          <p:spTgt spid="126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6" nodeType="withEffect" fill="hold" presetClass="exit" presetID="1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27" dur="2000"/>
                                        <p:tgtEl>
                                          <p:spTgt spid="127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nodeType="with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31" dur="2000"/>
                                        <p:tgtEl>
                                          <p:spTgt spid="12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2" fill="hold">
                            <p:stCondLst>
                              <p:cond delay="7000"/>
                            </p:stCondLst>
                            <p:childTnLst>
                              <p:par>
                                <p:cTn id="33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0 C 0.02413 0.00671 0.04844 0.01341 0.07309 0.00648 C 0.09774 -0.00046 0.12673 -0.02196 0.14757 -0.04231 C 0.1684 -0.06266 0.17309 -0.09318 0.19844 -0.1163 C 0.22378 -0.13942 0.2618 -0.16069 0.3 -0.18173 E">
                                      <p:cBhvr>
                                        <p:cTn id="34" dur="3000" fill="hold"/>
                                        <p:tgtEl>
                                          <p:spTgt spid="128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5" fill="hold">
                            <p:stCondLst>
                              <p:cond delay="10000"/>
                            </p:stCondLst>
                            <p:childTnLst>
                              <p:par>
                                <p:cTn id="36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0175 0.00185 C 0.00383 0.04884 0.00591 0.09583 0.01182 0.13518 C 0.01772 0.17454 0.01807 0.22222 0.03682 0.23843 C 0.05557 0.25463 0.09914 0.23426 0.12432 0.23194 C 0.14932 0.22963 0.15973 0.22639 0.18682 0.22523 C 0.2139 0.22407 0.24984 0.22454 0.28682 0.22523 E">
                                      <p:cBhvr>
                                        <p:cTn id="37" dur="3000" fill="hold"/>
                                        <p:tgtEl>
                                          <p:spTgt spid="129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8" fill="hold">
                            <p:stCondLst>
                              <p:cond delay="13000"/>
                            </p:stCondLst>
                            <p:childTnLst>
                              <p:par>
                                <p:cTn id="39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0087 0.00903 C -0.00834 0.01528 -0.03333 0.04653 -0.05468 0.04722 C -0.07603 0.04792 -0.11249 0.0206 -0.1276 0.01343 E">
                                      <p:cBhvr>
                                        <p:cTn id="40" dur="2000" fill="hold"/>
                                        <p:tgtEl>
                                          <p:spTgt spid="130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1" fill="hold">
                            <p:stCondLst>
                              <p:cond delay="15000"/>
                            </p:stCondLst>
                            <p:childTnLst>
                              <p:par>
                                <p:cTn id="42" nodeType="afterEffect" fill="hold" presetClass="exit" presetID="1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43" dur="2000"/>
                                        <p:tgtEl>
                                          <p:spTgt spid="129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5" nodeType="withEffect" fill="hold" presetClass="exit" presetID="1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46" dur="2000"/>
                                        <p:tgtEl>
                                          <p:spTgt spid="13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47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8" nodeType="with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50" dur="2000"/>
                                        <p:tgtEl>
                                          <p:spTgt spid="13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1" fill="hold">
                            <p:stCondLst>
                              <p:cond delay="17000"/>
                            </p:stCondLst>
                            <p:childTnLst>
                              <p:par>
                                <p:cTn id="52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1841 0.00185 C 0.04254 0.00857 0.06684 0.01528 0.0915 0.00833 C 0.11615 0.00139 0.14514 -0.02014 0.16598 -0.04051 C 0.18681 -0.06088 0.19306 -0.10139 0.21684 -0.11435 C 0.24063 -0.12731 0.28993 -0.11713 0.3092 -0.11782 E">
                                      <p:cBhvr>
                                        <p:cTn id="53" dur="3000" fill="hold"/>
                                        <p:tgtEl>
                                          <p:spTgt spid="131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4" fill="hold">
                            <p:stCondLst>
                              <p:cond delay="20000"/>
                            </p:stCondLst>
                            <p:childTnLst>
                              <p:par>
                                <p:cTn id="55" nodeType="after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57" dur="1000"/>
                                        <p:tgtEl>
                                          <p:spTgt spid="13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PlaceHolder 1"/>
          <p:cNvSpPr>
            <a:spLocks noGrp="1"/>
          </p:cNvSpPr>
          <p:nvPr>
            <p:ph type="title"/>
          </p:nvPr>
        </p:nvSpPr>
        <p:spPr>
          <a:xfrm>
            <a:off x="152280" y="-360"/>
            <a:ext cx="8761680" cy="60948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Times New Roman"/>
                <a:ea typeface="굴림"/>
              </a:rPr>
              <a:t>ACIDIFICATION OF URINE BY EXCRETION OF AMMONIA</a:t>
            </a: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34" name="Slide Number Placeholder 2"/>
          <p:cNvSpPr/>
          <p:nvPr/>
        </p:nvSpPr>
        <p:spPr>
          <a:xfrm>
            <a:off x="67816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EEA929-A7D0-4D65-8EC7-6EC2154E1357}" type="slidenum">
              <a:rPr b="0" lang="en-US" sz="10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35" name="AutoShape 2"/>
          <p:cNvSpPr/>
          <p:nvPr/>
        </p:nvSpPr>
        <p:spPr>
          <a:xfrm>
            <a:off x="228600" y="762120"/>
            <a:ext cx="2209680" cy="6095880"/>
          </a:xfrm>
          <a:prstGeom prst="can">
            <a:avLst>
              <a:gd name="adj" fmla="val 7398"/>
            </a:avLst>
          </a:prstGeom>
          <a:solidFill>
            <a:srgbClr val="ff4d23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36" name="AutoShape 4"/>
          <p:cNvSpPr/>
          <p:nvPr/>
        </p:nvSpPr>
        <p:spPr>
          <a:xfrm>
            <a:off x="4876920" y="762120"/>
            <a:ext cx="2514600" cy="6400800"/>
          </a:xfrm>
          <a:prstGeom prst="can">
            <a:avLst>
              <a:gd name="adj" fmla="val 7398"/>
            </a:avLst>
          </a:prstGeom>
          <a:solidFill>
            <a:srgbClr val="ff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37" name="AutoShape 5"/>
          <p:cNvSpPr/>
          <p:nvPr/>
        </p:nvSpPr>
        <p:spPr>
          <a:xfrm>
            <a:off x="2666880" y="304920"/>
            <a:ext cx="2514600" cy="2286000"/>
          </a:xfrm>
          <a:prstGeom prst="roundRect">
            <a:avLst>
              <a:gd name="adj" fmla="val 16667"/>
            </a:avLst>
          </a:prstGeom>
          <a:solidFill>
            <a:srgbClr val="66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38" name="AutoShape 6"/>
          <p:cNvSpPr/>
          <p:nvPr/>
        </p:nvSpPr>
        <p:spPr>
          <a:xfrm>
            <a:off x="2666880" y="2590920"/>
            <a:ext cx="2514600" cy="2286000"/>
          </a:xfrm>
          <a:prstGeom prst="roundRect">
            <a:avLst>
              <a:gd name="adj" fmla="val 16667"/>
            </a:avLst>
          </a:prstGeom>
          <a:solidFill>
            <a:srgbClr val="66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39" name="AutoShape 7"/>
          <p:cNvSpPr/>
          <p:nvPr/>
        </p:nvSpPr>
        <p:spPr>
          <a:xfrm>
            <a:off x="2666880" y="4876920"/>
            <a:ext cx="2514600" cy="2286000"/>
          </a:xfrm>
          <a:prstGeom prst="roundRect">
            <a:avLst>
              <a:gd name="adj" fmla="val 16667"/>
            </a:avLst>
          </a:prstGeom>
          <a:solidFill>
            <a:srgbClr val="66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40" name="AutoShape 8"/>
          <p:cNvSpPr/>
          <p:nvPr/>
        </p:nvSpPr>
        <p:spPr>
          <a:xfrm>
            <a:off x="7086600" y="304920"/>
            <a:ext cx="2514600" cy="2286000"/>
          </a:xfrm>
          <a:prstGeom prst="roundRect">
            <a:avLst>
              <a:gd name="adj" fmla="val 16667"/>
            </a:avLst>
          </a:prstGeom>
          <a:solidFill>
            <a:srgbClr val="66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41" name="AutoShape 9"/>
          <p:cNvSpPr/>
          <p:nvPr/>
        </p:nvSpPr>
        <p:spPr>
          <a:xfrm>
            <a:off x="7086600" y="2590920"/>
            <a:ext cx="2514600" cy="2286000"/>
          </a:xfrm>
          <a:prstGeom prst="roundRect">
            <a:avLst>
              <a:gd name="adj" fmla="val 16667"/>
            </a:avLst>
          </a:prstGeom>
          <a:solidFill>
            <a:srgbClr val="66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42" name="AutoShape 10"/>
          <p:cNvSpPr/>
          <p:nvPr/>
        </p:nvSpPr>
        <p:spPr>
          <a:xfrm>
            <a:off x="7086600" y="4876920"/>
            <a:ext cx="2514600" cy="2286000"/>
          </a:xfrm>
          <a:prstGeom prst="roundRect">
            <a:avLst>
              <a:gd name="adj" fmla="val 16667"/>
            </a:avLst>
          </a:prstGeom>
          <a:solidFill>
            <a:srgbClr val="66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43" name="Rectangle 11"/>
          <p:cNvSpPr/>
          <p:nvPr/>
        </p:nvSpPr>
        <p:spPr>
          <a:xfrm>
            <a:off x="0" y="0"/>
            <a:ext cx="9448920" cy="609480"/>
          </a:xfrm>
          <a:prstGeom prst="rect">
            <a:avLst/>
          </a:prstGeom>
          <a:solidFill>
            <a:srgbClr val="2b2b8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44" name="Text Box 13"/>
          <p:cNvSpPr/>
          <p:nvPr/>
        </p:nvSpPr>
        <p:spPr>
          <a:xfrm>
            <a:off x="685800" y="746280"/>
            <a:ext cx="144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00"/>
                </a:solidFill>
                <a:latin typeface="Arial"/>
              </a:rPr>
              <a:t>Capillary</a:t>
            </a: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45" name="Text Box 14"/>
          <p:cNvSpPr/>
          <p:nvPr/>
        </p:nvSpPr>
        <p:spPr>
          <a:xfrm>
            <a:off x="2666880" y="685800"/>
            <a:ext cx="2514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66ff"/>
                </a:solidFill>
                <a:latin typeface="Arial"/>
              </a:rPr>
              <a:t>Distal Tubule Cells</a:t>
            </a: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46" name="Text Box 15"/>
          <p:cNvSpPr/>
          <p:nvPr/>
        </p:nvSpPr>
        <p:spPr>
          <a:xfrm>
            <a:off x="5181480" y="6248520"/>
            <a:ext cx="190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191919"/>
                </a:solidFill>
                <a:latin typeface="Arial"/>
              </a:rPr>
              <a:t>Tubular Urine</a:t>
            </a: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47" name="Text Box 27"/>
          <p:cNvSpPr/>
          <p:nvPr/>
        </p:nvSpPr>
        <p:spPr>
          <a:xfrm>
            <a:off x="5638680" y="1371600"/>
            <a:ext cx="990720" cy="57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0066"/>
                </a:solidFill>
                <a:latin typeface="Arial"/>
              </a:rPr>
              <a:t>NH</a:t>
            </a:r>
            <a:r>
              <a:rPr b="0" lang="en-US" sz="2800" spc="-1" strike="noStrike" baseline="-25000">
                <a:solidFill>
                  <a:srgbClr val="ff0066"/>
                </a:solidFill>
                <a:latin typeface="Arial"/>
              </a:rPr>
              <a:t>3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48" name="Text Box 31"/>
          <p:cNvSpPr/>
          <p:nvPr/>
        </p:nvSpPr>
        <p:spPr>
          <a:xfrm>
            <a:off x="5257800" y="3200400"/>
            <a:ext cx="8380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0066"/>
                </a:solidFill>
                <a:latin typeface="Arial"/>
              </a:rPr>
              <a:t>Na</a:t>
            </a:r>
            <a:r>
              <a:rPr b="0" lang="en-US" sz="2800" spc="-1" strike="noStrike" baseline="30000">
                <a:solidFill>
                  <a:srgbClr val="ff0066"/>
                </a:solidFill>
                <a:latin typeface="Arial"/>
              </a:rPr>
              <a:t>+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49" name="Text Box 32"/>
          <p:cNvSpPr/>
          <p:nvPr/>
        </p:nvSpPr>
        <p:spPr>
          <a:xfrm>
            <a:off x="6400800" y="3200400"/>
            <a:ext cx="6858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0066"/>
                </a:solidFill>
                <a:latin typeface="Arial"/>
              </a:rPr>
              <a:t>Cl</a:t>
            </a:r>
            <a:r>
              <a:rPr b="0" lang="en-US" sz="2800" spc="-1" strike="noStrike" baseline="30000">
                <a:solidFill>
                  <a:srgbClr val="ff0066"/>
                </a:solidFill>
                <a:latin typeface="Arial"/>
              </a:rPr>
              <a:t>-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50" name="Text Box 33"/>
          <p:cNvSpPr/>
          <p:nvPr/>
        </p:nvSpPr>
        <p:spPr>
          <a:xfrm>
            <a:off x="6019920" y="3200400"/>
            <a:ext cx="3808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+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51" name="Text Box 44"/>
          <p:cNvSpPr/>
          <p:nvPr/>
        </p:nvSpPr>
        <p:spPr>
          <a:xfrm>
            <a:off x="3276720" y="3475080"/>
            <a:ext cx="1295280" cy="57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66ff"/>
                </a:solidFill>
                <a:latin typeface="Arial"/>
              </a:rPr>
              <a:t>H</a:t>
            </a:r>
            <a:r>
              <a:rPr b="0" lang="en-US" sz="2800" spc="-1" strike="noStrike" baseline="-25000">
                <a:solidFill>
                  <a:srgbClr val="0066ff"/>
                </a:solidFill>
                <a:latin typeface="Arial"/>
              </a:rPr>
              <a:t>2</a:t>
            </a:r>
            <a:r>
              <a:rPr b="0" lang="en-US" sz="2800" spc="-1" strike="noStrike">
                <a:solidFill>
                  <a:srgbClr val="0066ff"/>
                </a:solidFill>
                <a:latin typeface="Arial"/>
              </a:rPr>
              <a:t>CO</a:t>
            </a:r>
            <a:r>
              <a:rPr b="0" lang="en-US" sz="2800" spc="-1" strike="noStrike" baseline="-25000">
                <a:solidFill>
                  <a:srgbClr val="0066ff"/>
                </a:solidFill>
                <a:latin typeface="Arial"/>
              </a:rPr>
              <a:t>3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52" name="Text Box 48"/>
          <p:cNvSpPr/>
          <p:nvPr/>
        </p:nvSpPr>
        <p:spPr>
          <a:xfrm>
            <a:off x="2895480" y="3519360"/>
            <a:ext cx="1295640" cy="57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b050"/>
                </a:solidFill>
                <a:latin typeface="Arial"/>
              </a:rPr>
              <a:t>HCO</a:t>
            </a:r>
            <a:r>
              <a:rPr b="0" lang="en-US" sz="2800" spc="-1" strike="noStrike" baseline="-25000">
                <a:solidFill>
                  <a:srgbClr val="00b050"/>
                </a:solidFill>
                <a:latin typeface="Arial"/>
              </a:rPr>
              <a:t>3</a:t>
            </a:r>
            <a:r>
              <a:rPr b="0" lang="en-US" sz="2800" spc="-1" strike="noStrike" baseline="30000">
                <a:solidFill>
                  <a:srgbClr val="ff33cc"/>
                </a:solidFill>
                <a:latin typeface="Arial"/>
              </a:rPr>
              <a:t>-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53" name="Text Box 55"/>
          <p:cNvSpPr/>
          <p:nvPr/>
        </p:nvSpPr>
        <p:spPr>
          <a:xfrm>
            <a:off x="3994200" y="3517920"/>
            <a:ext cx="3808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54" name="Text Box 56"/>
          <p:cNvSpPr/>
          <p:nvPr/>
        </p:nvSpPr>
        <p:spPr>
          <a:xfrm>
            <a:off x="5562720" y="3214800"/>
            <a:ext cx="12189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990000"/>
                </a:solidFill>
                <a:latin typeface="Arial"/>
              </a:rPr>
              <a:t>NaCl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55" name="Text Box 19"/>
          <p:cNvSpPr/>
          <p:nvPr/>
        </p:nvSpPr>
        <p:spPr>
          <a:xfrm>
            <a:off x="3124080" y="4114800"/>
            <a:ext cx="1828800" cy="579600"/>
          </a:xfrm>
          <a:prstGeom prst="rect">
            <a:avLst/>
          </a:prstGeom>
          <a:solidFill>
            <a:srgbClr val="66ff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NaHCO</a:t>
            </a:r>
            <a:r>
              <a:rPr b="0" lang="en-US" sz="2800" spc="-1" strike="noStrike" baseline="-25000">
                <a:solidFill>
                  <a:srgbClr val="ffffff"/>
                </a:solidFill>
                <a:latin typeface="Arial"/>
              </a:rPr>
              <a:t>3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56" name="Text Box 57"/>
          <p:cNvSpPr/>
          <p:nvPr/>
        </p:nvSpPr>
        <p:spPr>
          <a:xfrm>
            <a:off x="914400" y="5715000"/>
            <a:ext cx="2895480" cy="825480"/>
          </a:xfrm>
          <a:prstGeom prst="rect">
            <a:avLst/>
          </a:prstGeom>
          <a:solidFill>
            <a:srgbClr val="ffcccc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Click Mouse to Start Animation</a:t>
            </a:r>
            <a:endParaRPr b="0" lang="en-US" sz="24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57" name="Text Box 58"/>
          <p:cNvSpPr/>
          <p:nvPr/>
        </p:nvSpPr>
        <p:spPr>
          <a:xfrm>
            <a:off x="3124080" y="4181400"/>
            <a:ext cx="1828800" cy="457200"/>
          </a:xfrm>
          <a:prstGeom prst="rect">
            <a:avLst/>
          </a:prstGeom>
          <a:solidFill>
            <a:srgbClr val="66ff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58" name="Text Box 59"/>
          <p:cNvSpPr/>
          <p:nvPr/>
        </p:nvSpPr>
        <p:spPr>
          <a:xfrm>
            <a:off x="3124080" y="4119480"/>
            <a:ext cx="1828800" cy="57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NaHCO</a:t>
            </a:r>
            <a:r>
              <a:rPr b="0" lang="en-US" sz="28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59" name="Text Box 51"/>
          <p:cNvSpPr/>
          <p:nvPr/>
        </p:nvSpPr>
        <p:spPr>
          <a:xfrm>
            <a:off x="5410080" y="4648320"/>
            <a:ext cx="1524240" cy="57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NH</a:t>
            </a:r>
            <a:r>
              <a:rPr b="0" lang="en-US" sz="28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</a:t>
            </a:r>
            <a:r>
              <a:rPr b="0" lang="en-US" sz="2800" spc="-1" strike="noStrike" baseline="30000">
                <a:solidFill>
                  <a:srgbClr val="000000"/>
                </a:solidFill>
                <a:latin typeface="Arial"/>
              </a:rPr>
              <a:t>-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60" name="Text Box 23"/>
          <p:cNvSpPr/>
          <p:nvPr/>
        </p:nvSpPr>
        <p:spPr>
          <a:xfrm>
            <a:off x="4343400" y="3519360"/>
            <a:ext cx="6094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0000"/>
                </a:solidFill>
                <a:latin typeface="Arial"/>
              </a:rPr>
              <a:t>H</a:t>
            </a:r>
            <a:r>
              <a:rPr b="0" lang="en-US" sz="2800" spc="-1" strike="noStrike" baseline="30000">
                <a:solidFill>
                  <a:srgbClr val="ff0000"/>
                </a:solidFill>
                <a:latin typeface="Arial"/>
              </a:rPr>
              <a:t>+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61" name="Text Box 61"/>
          <p:cNvSpPr/>
          <p:nvPr/>
        </p:nvSpPr>
        <p:spPr>
          <a:xfrm>
            <a:off x="5410080" y="5195880"/>
            <a:ext cx="1447920" cy="57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2060"/>
                </a:solidFill>
                <a:latin typeface="Arial"/>
              </a:rPr>
              <a:t>NH</a:t>
            </a:r>
            <a:r>
              <a:rPr b="0" lang="en-US" sz="2800" spc="-1" strike="noStrike" baseline="-25000">
                <a:solidFill>
                  <a:srgbClr val="002060"/>
                </a:solidFill>
                <a:latin typeface="Arial"/>
              </a:rPr>
              <a:t>4</a:t>
            </a:r>
            <a:r>
              <a:rPr b="0" lang="en-US" sz="2800" spc="-1" strike="noStrike">
                <a:solidFill>
                  <a:srgbClr val="002060"/>
                </a:solidFill>
                <a:latin typeface="Arial"/>
              </a:rPr>
              <a:t>Cl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62" name="Text Box 62"/>
          <p:cNvSpPr/>
          <p:nvPr/>
        </p:nvSpPr>
        <p:spPr>
          <a:xfrm>
            <a:off x="914400" y="5715000"/>
            <a:ext cx="3276720" cy="825480"/>
          </a:xfrm>
          <a:prstGeom prst="rect">
            <a:avLst/>
          </a:prstGeom>
          <a:solidFill>
            <a:srgbClr val="ffcccc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7030a0"/>
                </a:solidFill>
                <a:latin typeface="Arial"/>
              </a:rPr>
              <a:t>Click to See Animation Again</a:t>
            </a:r>
            <a:endParaRPr b="0" lang="en-US" sz="24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63" name="Text Box 63"/>
          <p:cNvSpPr/>
          <p:nvPr/>
        </p:nvSpPr>
        <p:spPr>
          <a:xfrm>
            <a:off x="7010280" y="609480"/>
            <a:ext cx="2278080" cy="228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2060"/>
                </a:solidFill>
                <a:latin typeface="Arial"/>
              </a:rPr>
              <a:t>Note the</a:t>
            </a:r>
            <a:br>
              <a:rPr sz="2400"/>
            </a:br>
            <a:r>
              <a:rPr b="0" lang="en-US" sz="2400" spc="-1" strike="noStrike">
                <a:solidFill>
                  <a:srgbClr val="002060"/>
                </a:solidFill>
                <a:latin typeface="Arial"/>
              </a:rPr>
              <a:t>H</a:t>
            </a:r>
            <a:r>
              <a:rPr b="0" lang="en-US" sz="2400" spc="-1" strike="noStrike" baseline="30000">
                <a:solidFill>
                  <a:srgbClr val="002060"/>
                </a:solidFill>
                <a:latin typeface="Arial"/>
              </a:rPr>
              <a:t>+</a:t>
            </a:r>
            <a:r>
              <a:rPr b="0" lang="en-US" sz="2400" spc="-1" strike="noStrike">
                <a:solidFill>
                  <a:srgbClr val="002060"/>
                </a:solidFill>
                <a:latin typeface="Arial"/>
              </a:rPr>
              <a:t> - Na</a:t>
            </a:r>
            <a:r>
              <a:rPr b="0" lang="en-US" sz="2400" spc="-1" strike="noStrike" baseline="30000">
                <a:solidFill>
                  <a:srgbClr val="002060"/>
                </a:solidFill>
                <a:latin typeface="Arial"/>
              </a:rPr>
              <a:t>+</a:t>
            </a:r>
            <a:r>
              <a:rPr b="0" lang="en-US" sz="2400" spc="-1" strike="noStrike">
                <a:solidFill>
                  <a:srgbClr val="002060"/>
                </a:solidFill>
                <a:latin typeface="Arial"/>
              </a:rPr>
              <a:t> exchange to  maintain electrical neutrality</a:t>
            </a:r>
            <a:endParaRPr b="0" lang="en-US" sz="2400" spc="-1" strike="noStrike">
              <a:solidFill>
                <a:srgbClr val="ffffff"/>
              </a:solidFill>
              <a:latin typeface="굴림"/>
            </a:endParaRPr>
          </a:p>
        </p:txBody>
      </p:sp>
      <p:pic>
        <p:nvPicPr>
          <p:cNvPr id="164" name="Picture 66" descr="rbc"/>
          <p:cNvPicPr/>
          <p:nvPr/>
        </p:nvPicPr>
        <p:blipFill>
          <a:blip r:embed="rId1"/>
          <a:srcRect l="0" t="0" r="51353" b="45224"/>
          <a:stretch/>
        </p:blipFill>
        <p:spPr>
          <a:xfrm>
            <a:off x="914400" y="-1066680"/>
            <a:ext cx="549360" cy="609480"/>
          </a:xfrm>
          <a:prstGeom prst="rect">
            <a:avLst/>
          </a:prstGeom>
          <a:ln w="0">
            <a:noFill/>
          </a:ln>
        </p:spPr>
      </p:pic>
      <p:pic>
        <p:nvPicPr>
          <p:cNvPr id="165" name="Picture 67" descr="rbc"/>
          <p:cNvPicPr/>
          <p:nvPr/>
        </p:nvPicPr>
        <p:blipFill>
          <a:blip r:embed="rId2"/>
          <a:srcRect l="0" t="0" r="51353" b="45224"/>
          <a:stretch/>
        </p:blipFill>
        <p:spPr>
          <a:xfrm rot="19830600">
            <a:off x="1600200" y="-1219320"/>
            <a:ext cx="549360" cy="609840"/>
          </a:xfrm>
          <a:prstGeom prst="rect">
            <a:avLst/>
          </a:prstGeom>
          <a:ln w="0">
            <a:noFill/>
          </a:ln>
        </p:spPr>
      </p:pic>
      <p:pic>
        <p:nvPicPr>
          <p:cNvPr id="166" name="Picture 68" descr="rbc"/>
          <p:cNvPicPr/>
          <p:nvPr/>
        </p:nvPicPr>
        <p:blipFill>
          <a:blip r:embed="rId3"/>
          <a:srcRect l="0" t="0" r="51353" b="45224"/>
          <a:stretch/>
        </p:blipFill>
        <p:spPr>
          <a:xfrm rot="19806000">
            <a:off x="456840" y="-609480"/>
            <a:ext cx="549360" cy="609480"/>
          </a:xfrm>
          <a:prstGeom prst="rect">
            <a:avLst/>
          </a:prstGeom>
          <a:ln w="0">
            <a:noFill/>
          </a:ln>
        </p:spPr>
      </p:pic>
      <p:pic>
        <p:nvPicPr>
          <p:cNvPr id="167" name="Picture 69" descr="rbc"/>
          <p:cNvPicPr/>
          <p:nvPr/>
        </p:nvPicPr>
        <p:blipFill>
          <a:blip r:embed="rId4"/>
          <a:srcRect l="51367" t="45210" r="0" b="0"/>
          <a:stretch/>
        </p:blipFill>
        <p:spPr>
          <a:xfrm rot="19103400">
            <a:off x="334440" y="-1523880"/>
            <a:ext cx="549360" cy="609480"/>
          </a:xfrm>
          <a:prstGeom prst="rect">
            <a:avLst/>
          </a:prstGeom>
          <a:ln w="0">
            <a:noFill/>
          </a:ln>
        </p:spPr>
      </p:pic>
      <p:pic>
        <p:nvPicPr>
          <p:cNvPr id="168" name="Picture 70" descr="rbc"/>
          <p:cNvPicPr/>
          <p:nvPr/>
        </p:nvPicPr>
        <p:blipFill>
          <a:blip r:embed="rId5"/>
          <a:srcRect l="45210" t="0" r="0" b="51367"/>
          <a:stretch/>
        </p:blipFill>
        <p:spPr>
          <a:xfrm rot="19191000">
            <a:off x="1371240" y="-549360"/>
            <a:ext cx="609480" cy="549360"/>
          </a:xfrm>
          <a:prstGeom prst="rect">
            <a:avLst/>
          </a:prstGeom>
          <a:ln w="0">
            <a:noFill/>
          </a:ln>
        </p:spPr>
      </p:pic>
      <p:pic>
        <p:nvPicPr>
          <p:cNvPr id="169" name="Picture 71" descr="rbc"/>
          <p:cNvPicPr/>
          <p:nvPr/>
        </p:nvPicPr>
        <p:blipFill>
          <a:blip r:embed="rId6"/>
          <a:srcRect l="0" t="51367" r="45210" b="0"/>
          <a:stretch/>
        </p:blipFill>
        <p:spPr>
          <a:xfrm rot="346200">
            <a:off x="1066680" y="-1874520"/>
            <a:ext cx="609840" cy="549360"/>
          </a:xfrm>
          <a:prstGeom prst="rect">
            <a:avLst/>
          </a:prstGeom>
          <a:ln w="0">
            <a:noFill/>
          </a:ln>
        </p:spPr>
      </p:pic>
      <p:sp>
        <p:nvSpPr>
          <p:cNvPr id="170" name="Text Box 72"/>
          <p:cNvSpPr/>
          <p:nvPr/>
        </p:nvSpPr>
        <p:spPr>
          <a:xfrm>
            <a:off x="2819520" y="2666880"/>
            <a:ext cx="20574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191919"/>
                </a:solidFill>
                <a:latin typeface="Arial"/>
              </a:rPr>
              <a:t>Dissociation of carbonic acid</a:t>
            </a: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58" dur="indefinite" restart="never" nodeType="tmRoot">
          <p:childTnLst>
            <p:seq>
              <p:cTn id="59" dur="indefinite" nodeType="mainSeq">
                <p:childTnLst>
                  <p:par>
                    <p:cTn id="60" fill="hold">
                      <p:stCondLst>
                        <p:cond delay="indefinite"/>
                      </p:stCondLst>
                      <p:childTnLst>
                        <p:par>
                          <p:cTn id="61" fill="hold">
                            <p:stCondLst>
                              <p:cond delay="0"/>
                            </p:stCondLst>
                            <p:childTnLst>
                              <p:par>
                                <p:cTn id="62" nodeType="clickEffect" fill="hold" presetClass="exit" presetID="1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63" dur="2000"/>
                                        <p:tgtEl>
                                          <p:spTgt spid="156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64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5" nodeType="withEffect" fill="hold" presetClass="emph" presetID="8" repeatCount="indefinite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66" dur="2000" fill="hold"/>
                                        <p:tgtEl>
                                          <p:spTgt spid="167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67" nodeType="withEffect" fill="hold" presetClass="emph" presetID="8" repeatCount="indefinite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68" dur="2000" fill="hold"/>
                                        <p:tgtEl>
                                          <p:spTgt spid="16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69" nodeType="withEffect" fill="hold" presetClass="emph" presetID="8" repeatCount="indefinite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70" dur="2000" fill="hold"/>
                                        <p:tgtEl>
                                          <p:spTgt spid="165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1" nodeType="withEffect" fill="hold" presetClass="emph" presetID="8" repeatCount="indefinite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72" dur="2000" fill="hold"/>
                                        <p:tgtEl>
                                          <p:spTgt spid="16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3" nodeType="withEffect" fill="hold" presetClass="emph" presetID="8" repeatCount="indefinite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74" dur="2000" fill="hold"/>
                                        <p:tgtEl>
                                          <p:spTgt spid="166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5" nodeType="withEffect" fill="hold" presetClass="emph" presetID="8" repeatCount="indefinite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76" dur="2000" fill="hold"/>
                                        <p:tgtEl>
                                          <p:spTgt spid="16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7" nodeType="withEffect" fill="hold" presetClass="path" presetID="0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1562 -0.20417 C -0.01424 -0.15093 -0.01319 0.03865 -0.00764 0.1199 C -0.00208 0.20115 0.00903 0.22129 0.01736 0.28333 C 0.02569 0.34537 0.04601 0.43333 0.04236 0.49328 C 0.03872 0.55324 0.00747 0.59004 -0.00503 0.64328 C -0.01753 0.69606 -0.0276 0.76041 -0.03264 0.81296 C -0.03767 0.86574 -0.03299 0.91041 -0.03507 0.95995 C -0.03715 1.00949 -0.04635 1.06944 -0.04514 1.10995 C -0.04392 1.15023 -0.03264 1.15208 -0.0276 1.20324 C -0.02257 1.25439 -0.01927 1.37222 -0.0151 1.41666 C -0.01094 1.46111 -0.00677 1.46551 -0.0026 1.4699 E">
                                      <p:cBhvr>
                                        <p:cTn id="78" dur="3000" fill="hold"/>
                                        <p:tgtEl>
                                          <p:spTgt spid="169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79" nodeType="withEffect" fill="hold" presetClass="path" presetID="0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1685 -0.17917 C 0.01042 -0.10903 -0.00503 0.14722 -0.02187 0.24583 C -0.03871 0.34444 -0.06927 0.3493 -0.08437 0.4125 C -0.09947 0.47569 -0.11406 0.5493 -0.1125 0.625 C -0.11093 0.70069 -0.09375 0.80208 -0.075 0.86666 C -0.05625 0.93125 -0.01406 0.95555 -4.72222E-006 1.0125 C 0.01407 1.06944 0.01164 1.13889 0.00938 1.20833 E">
                                      <p:cBhvr>
                                        <p:cTn id="80" dur="3000" fill="hold"/>
                                        <p:tgtEl>
                                          <p:spTgt spid="165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81" nodeType="withEffect" fill="hold" presetClass="path" presetID="0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33333E-006 3.7037E-006 C -0.03281 0.06505 -0.06562 0.13032 -0.075 0.1875 C -0.08437 0.24444 -0.06875 0.27986 -0.05625 0.34167 C -0.04375 0.40324 -0.01354 0.49028 3.33333E-006 0.55833 C 0.01354 0.62639 0.01979 0.68472 0.025 0.75 C 0.03021 0.81505 0.03646 0.89074 0.03125 0.95 C 0.02604 1.00903 0.0099 1.05648 -0.00625 1.10417 E">
                                      <p:cBhvr>
                                        <p:cTn id="82" dur="3000" fill="hold"/>
                                        <p:tgtEl>
                                          <p:spTgt spid="168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83" nodeType="withEffect" fill="hold" presetClass="path" presetID="0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9.72222E-006 -1.11111E-006 C -0.02187 0.08403 -0.04374 0.16806 -0.05312 0.2375 C -0.06249 0.30694 -0.06041 0.35347 -0.05624 0.41667 C -0.05208 0.47986 -0.0427 0.54931 -0.02812 0.61667 C -0.01354 0.68403 0.01198 0.74861 0.03126 0.82083 C 0.05053 0.89306 0.07084 0.98958 0.08751 1.05 C 0.10417 1.11042 0.11771 1.14676 0.13126 1.18333 E">
                                      <p:cBhvr>
                                        <p:cTn id="84" dur="3000" fill="hold"/>
                                        <p:tgtEl>
                                          <p:spTgt spid="164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85" nodeType="withEffect" fill="hold" presetClass="path" presetID="0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3542 -0.13055 C -0.02327 -0.08102 0.01597 0.09144 0.04062 0.17084 C 0.06527 0.25023 0.09375 0.29028 0.1125 0.34584 C 0.13125 0.40139 0.14896 0.44097 0.15312 0.50394 C 0.15729 0.56713 0.15104 0.64653 0.1375 0.72477 C 0.12396 0.80347 0.09635 0.89931 0.07187 0.975 C 0.04739 1.05047 0.00781 1.13172 -0.00938 1.17917 C -0.02657 1.22639 -0.029 1.24236 -0.03125 1.25834 E">
                                      <p:cBhvr>
                                        <p:cTn id="86" dur="3000" fill="hold"/>
                                        <p:tgtEl>
                                          <p:spTgt spid="167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87" nodeType="withEffect" fill="hold" presetClass="path" presetID="0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9.72222E-006 -7.77778E-006 C 0.02101 0.0611 0.04219 0.12222 0.05626 0.24583 C 0.07032 0.36944 0.07969 0.59791 0.08438 0.74166 C 0.08907 0.88518 0.08664 0.99675 0.08438 1.10833 E">
                                      <p:cBhvr>
                                        <p:cTn id="88" dur="3000" fill="hold"/>
                                        <p:tgtEl>
                                          <p:spTgt spid="166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9" fill="hold">
                            <p:stCondLst>
                              <p:cond delay="3000"/>
                            </p:stCondLst>
                            <p:childTnLst>
                              <p:par>
                                <p:cTn id="90" nodeType="afterEffect" fill="hold" presetClass="exit" presetID="1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91" dur="2000"/>
                                        <p:tgtEl>
                                          <p:spTgt spid="15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92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3" nodeType="with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95" dur="2000"/>
                                        <p:tgtEl>
                                          <p:spTgt spid="15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96" nodeType="with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98" dur="2000"/>
                                        <p:tgtEl>
                                          <p:spTgt spid="15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99" nodeType="with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101" dur="2000"/>
                                        <p:tgtEl>
                                          <p:spTgt spid="16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02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4" fill="hold">
                            <p:stCondLst>
                              <p:cond delay="5000"/>
                            </p:stCondLst>
                            <p:childTnLst>
                              <p:par>
                                <p:cTn id="105" nodeType="afterEffect" fill="hold" presetClass="exit" presetID="10">
                                  <p:stCondLst>
                                    <p:cond delay="200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106" dur="2000"/>
                                        <p:tgtEl>
                                          <p:spTgt spid="153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07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5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8" fill="hold">
                            <p:stCondLst>
                              <p:cond delay="9000"/>
                            </p:stCondLst>
                            <p:childTnLst>
                              <p:par>
                                <p:cTn id="109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5.55112E-017 4.07407E-006 C -0.00417 0.01782 -0.00729 0.03912 -0.00486 0.05347 C -0.00243 0.06782 0.00538 0.07916 0.01493 0.08564 C 0.02448 0.09213 0.04462 0.09097 0.05243 0.09236 E">
                                      <p:cBhvr>
                                        <p:cTn id="110" dur="3000" fill="hold"/>
                                        <p:tgtEl>
                                          <p:spTgt spid="152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1" fill="hold">
                            <p:stCondLst>
                              <p:cond delay="12000"/>
                            </p:stCondLst>
                            <p:childTnLst>
                              <p:par>
                                <p:cTn id="112" nodeType="afterEffect" fill="hold" presetClass="exit" presetID="1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113" dur="2000"/>
                                        <p:tgtEl>
                                          <p:spTgt spid="15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14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5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5" nodeType="withEffect" fill="hold" presetClass="exit" presetID="1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116" dur="1000"/>
                                        <p:tgtEl>
                                          <p:spTgt spid="17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17" dur="1" fill="hold">
                                          <p:stCondLst>
                                            <p:cond delay="999"/>
                                          </p:stCondLst>
                                        </p:cTn>
                                        <p:tgtEl>
                                          <p:spTgt spid="1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8" nodeType="with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120" dur="2000"/>
                                        <p:tgtEl>
                                          <p:spTgt spid="15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21" nodeType="with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123" dur="2000"/>
                                        <p:tgtEl>
                                          <p:spTgt spid="14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24" nodeType="with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126" dur="2000"/>
                                        <p:tgtEl>
                                          <p:spTgt spid="14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7" fill="hold">
                            <p:stCondLst>
                              <p:cond delay="14000"/>
                            </p:stCondLst>
                            <p:childTnLst>
                              <p:par>
                                <p:cTn id="128" nodeType="afterEffect" fill="hold" presetClass="exit" presetID="10">
                                  <p:stCondLst>
                                    <p:cond delay="200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129" dur="2000"/>
                                        <p:tgtEl>
                                          <p:spTgt spid="15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30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1" fill="hold">
                            <p:stCondLst>
                              <p:cond delay="18000"/>
                            </p:stCondLst>
                            <p:childTnLst>
                              <p:par>
                                <p:cTn id="132" nodeType="after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134" dur="2000"/>
                                        <p:tgtEl>
                                          <p:spTgt spid="16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5" fill="hold">
                            <p:stCondLst>
                              <p:cond delay="20000"/>
                            </p:stCondLst>
                            <p:childTnLst>
                              <p:par>
                                <p:cTn id="136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33333E-006 1.85185E-006 C -0.02847 0.01227 -0.05677 0.02454 -0.08264 0.0368 C -0.1085 0.04907 -0.13784 0.05579 -0.15503 0.07338 C -0.17222 0.09097 -0.17934 0.12801 -0.18576 0.14236 E">
                                      <p:cBhvr>
                                        <p:cTn id="137" dur="2000" fill="hold"/>
                                        <p:tgtEl>
                                          <p:spTgt spid="148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8" fill="hold">
                            <p:stCondLst>
                              <p:cond delay="22000"/>
                            </p:stCondLst>
                            <p:childTnLst>
                              <p:par>
                                <p:cTn id="139" nodeType="after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141" dur="2000"/>
                                        <p:tgtEl>
                                          <p:spTgt spid="15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42" fill="hold">
                            <p:stCondLst>
                              <p:cond delay="24000"/>
                            </p:stCondLst>
                            <p:childTnLst>
                              <p:par>
                                <p:cTn id="143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33333E-006 -1.48148E-006 C 0.02205 0.04236 0.0441 0.08496 0.0375 0.10996 C 0.03091 0.13496 -0.02552 0.11945 -0.0401 0.15 C -0.05468 0.18056 -0.06302 0.25394 -0.05 0.29329 C -0.03698 0.33264 0.02657 0.3544 0.0375 0.38658 C 0.04844 0.41875 0.02014 0.46528 0.01563 0.48588 E">
                                      <p:cBhvr>
                                        <p:cTn id="144" dur="3000" fill="hold"/>
                                        <p:tgtEl>
                                          <p:spTgt spid="147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45" fill="hold">
                            <p:stCondLst>
                              <p:cond delay="27000"/>
                            </p:stCondLst>
                            <p:childTnLst>
                              <p:par>
                                <p:cTn id="146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1.85185E-006 C 0.01684 0.03055 0.03385 0.06111 0.0276 0.08009 C 0.02135 0.09907 -0.01701 0.10185 -0.0375 0.11342 C -0.05799 0.125 -0.09028 0.13241 -0.09497 0.15 C -0.09965 0.16759 -0.0717 0.20486 -0.06562 0.21921 E">
                                      <p:cBhvr>
                                        <p:cTn id="147" dur="3000" fill="hold"/>
                                        <p:tgtEl>
                                          <p:spTgt spid="149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48" fill="hold">
                            <p:stCondLst>
                              <p:cond delay="30000"/>
                            </p:stCondLst>
                            <p:childTnLst>
                              <p:par>
                                <p:cTn id="149" nodeType="after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151" dur="2000"/>
                                        <p:tgtEl>
                                          <p:spTgt spid="15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52" nodeType="withEffect" fill="hold" presetClass="exit" presetID="1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153" dur="2000"/>
                                        <p:tgtEl>
                                          <p:spTgt spid="147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54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5" nodeType="withEffect" fill="hold" presetClass="exit" presetID="1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156" dur="2000"/>
                                        <p:tgtEl>
                                          <p:spTgt spid="149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57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58" fill="hold">
                            <p:stCondLst>
                              <p:cond delay="32000"/>
                            </p:stCondLst>
                            <p:childTnLst>
                              <p:par>
                                <p:cTn id="159" nodeType="after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1" fill="hold">
                            <p:stCondLst>
                              <p:cond delay="32000"/>
                            </p:stCondLst>
                            <p:childTnLst>
                              <p:par>
                                <p:cTn id="162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33333E-006 4.07407E-006 C 0.00903 0.00138 0.03438 0.0037 0.05417 0.00902 C 0.07396 0.01435 0.1125 0.01527 0.1191 0.0324 C 0.1257 0.04953 0.1033 0.08634 0.0941 0.1125 C 0.0849 0.13865 0.05556 0.16481 0.06424 0.18912 C 0.07292 0.21342 0.12952 0.24444 0.1467 0.25902 E">
                                      <p:cBhvr>
                                        <p:cTn id="163" dur="3000" fill="hold"/>
                                        <p:tgtEl>
                                          <p:spTgt spid="160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4" fill="hold">
                            <p:stCondLst>
                              <p:cond delay="35000"/>
                            </p:stCondLst>
                            <p:childTnLst>
                              <p:par>
                                <p:cTn id="165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11022E-016 7.40741E-007 C 0.00122 0.00856 0.00781 0.03588 0.00747 0.05116 C 0.00712 0.06643 -0.00035 0.08287 -0.00243 0.0912 E">
                                      <p:cBhvr>
                                        <p:cTn id="166" dur="2000" fill="hold"/>
                                        <p:tgtEl>
                                          <p:spTgt spid="159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7" fill="hold">
                            <p:stCondLst>
                              <p:cond delay="37000"/>
                            </p:stCondLst>
                            <p:childTnLst>
                              <p:par>
                                <p:cTn id="168" nodeType="after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170" dur="2000"/>
                                        <p:tgtEl>
                                          <p:spTgt spid="15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1" fill="hold">
                            <p:stCondLst>
                              <p:cond delay="39000"/>
                            </p:stCondLst>
                            <p:childTnLst>
                              <p:par>
                                <p:cTn id="172" nodeType="afterEffect" fill="hold" presetClass="exit" presetID="1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173" dur="2000"/>
                                        <p:tgtEl>
                                          <p:spTgt spid="159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74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5" nodeType="withEffect" fill="hold" presetClass="exit" presetID="1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176" dur="2000"/>
                                        <p:tgtEl>
                                          <p:spTgt spid="16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77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8" nodeType="with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180" dur="2000"/>
                                        <p:tgtEl>
                                          <p:spTgt spid="16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81" fill="hold">
                            <p:stCondLst>
                              <p:cond delay="41000"/>
                            </p:stCondLst>
                            <p:childTnLst>
                              <p:par>
                                <p:cTn id="182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33333E-006 -4.44444E-006 C -0.00816 0.00741 -0.03473 0.0338 -0.04914 0.04468 C -0.06354 0.05556 -0.07084 0.06366 -0.08664 0.06482 C -0.10261 0.06598 -0.12153 0.05741 -0.14427 0.05139 C -0.16667 0.04537 -0.19514 0.04908 -0.2217 0.02801 C -0.24827 0.00695 -0.28924 -0.103 -0.30417 -0.07523 C -0.3191 -0.04745 -0.31042 0.11412 -0.31164 0.19468 C -0.31285 0.27524 -0.31164 0.36366 -0.31164 0.40811 E">
                                      <p:cBhvr>
                                        <p:cTn id="183" dur="5100" fill="hold"/>
                                        <p:tgtEl>
                                          <p:spTgt spid="158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84" fill="hold">
                            <p:stCondLst>
                              <p:cond delay="46100"/>
                            </p:stCondLst>
                            <p:childTnLst>
                              <p:par>
                                <p:cTn id="185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0 C 0.02204 -0.03056 0.04427 -0.06111 0.04253 -0.09676 C 0.04079 -0.13241 -0.004 -0.17338 -0.0099 -0.21343 C -0.0158 -0.25347 0.00781 -0.3 0.00746 -0.33657 C 0.00711 -0.37315 -0.00539 -0.40324 -0.0125 -0.43333 C -0.01962 -0.46343 -0.03941 -0.49005 -0.0349 -0.51667 C -0.03039 -0.54329 0.0052 -0.56597 0.0151 -0.59329 C 0.025 -0.6206 0.02916 -0.65463 0.025 -0.68009 C 0.02083 -0.70556 -0.00244 -0.72569 -0.0099 -0.74676 C -0.01737 -0.76782 -0.01997 -0.7912 -0.01997 -0.80671 C -0.01997 -0.82199 -0.01494 -0.83125 -0.0099 -0.84005 E">
                                      <p:cBhvr>
                                        <p:cTn id="186" dur="3000" fill="hold"/>
                                        <p:tgtEl>
                                          <p:spTgt spid="161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87" fill="hold">
                            <p:stCondLst>
                              <p:cond delay="49100"/>
                            </p:stCondLst>
                            <p:childTnLst>
                              <p:par>
                                <p:cTn id="188" nodeType="after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190" dur="2000"/>
                                        <p:tgtEl>
                                          <p:spTgt spid="16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152280" y="-360"/>
            <a:ext cx="8761680" cy="60948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lnSpc>
                <a:spcPct val="8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Times New Roman"/>
                <a:ea typeface="굴림"/>
              </a:rPr>
              <a:t>ACIDIFICATION OF URINE BY EXCRETION OF AMMONIA</a:t>
            </a: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2" name="Slide Number Placeholder 2"/>
          <p:cNvSpPr/>
          <p:nvPr/>
        </p:nvSpPr>
        <p:spPr>
          <a:xfrm>
            <a:off x="67816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A25497B-3310-4776-9F9B-2BEB5C901C2E}" type="slidenum">
              <a:rPr b="0" lang="en-US" sz="10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73" name="AutoShape 2"/>
          <p:cNvSpPr/>
          <p:nvPr/>
        </p:nvSpPr>
        <p:spPr>
          <a:xfrm>
            <a:off x="228600" y="762120"/>
            <a:ext cx="2209680" cy="6095880"/>
          </a:xfrm>
          <a:prstGeom prst="can">
            <a:avLst>
              <a:gd name="adj" fmla="val 7398"/>
            </a:avLst>
          </a:prstGeom>
          <a:solidFill>
            <a:srgbClr val="ff4d23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74" name="AutoShape 3"/>
          <p:cNvSpPr/>
          <p:nvPr/>
        </p:nvSpPr>
        <p:spPr>
          <a:xfrm>
            <a:off x="4876920" y="762120"/>
            <a:ext cx="2514600" cy="6400800"/>
          </a:xfrm>
          <a:prstGeom prst="can">
            <a:avLst>
              <a:gd name="adj" fmla="val 7398"/>
            </a:avLst>
          </a:prstGeom>
          <a:solidFill>
            <a:srgbClr val="ff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75" name="AutoShape 4"/>
          <p:cNvSpPr/>
          <p:nvPr/>
        </p:nvSpPr>
        <p:spPr>
          <a:xfrm>
            <a:off x="2666880" y="304920"/>
            <a:ext cx="2514600" cy="2286000"/>
          </a:xfrm>
          <a:prstGeom prst="roundRect">
            <a:avLst>
              <a:gd name="adj" fmla="val 16667"/>
            </a:avLst>
          </a:prstGeom>
          <a:solidFill>
            <a:srgbClr val="66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76" name="AutoShape 5"/>
          <p:cNvSpPr/>
          <p:nvPr/>
        </p:nvSpPr>
        <p:spPr>
          <a:xfrm>
            <a:off x="2666880" y="2590920"/>
            <a:ext cx="2514600" cy="2286000"/>
          </a:xfrm>
          <a:prstGeom prst="roundRect">
            <a:avLst>
              <a:gd name="adj" fmla="val 16667"/>
            </a:avLst>
          </a:prstGeom>
          <a:solidFill>
            <a:srgbClr val="66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77" name="AutoShape 6"/>
          <p:cNvSpPr/>
          <p:nvPr/>
        </p:nvSpPr>
        <p:spPr>
          <a:xfrm>
            <a:off x="2666880" y="4876920"/>
            <a:ext cx="2514600" cy="2286000"/>
          </a:xfrm>
          <a:prstGeom prst="roundRect">
            <a:avLst>
              <a:gd name="adj" fmla="val 16667"/>
            </a:avLst>
          </a:prstGeom>
          <a:solidFill>
            <a:srgbClr val="66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78" name="AutoShape 7"/>
          <p:cNvSpPr/>
          <p:nvPr/>
        </p:nvSpPr>
        <p:spPr>
          <a:xfrm>
            <a:off x="7086600" y="304920"/>
            <a:ext cx="2514600" cy="2286000"/>
          </a:xfrm>
          <a:prstGeom prst="roundRect">
            <a:avLst>
              <a:gd name="adj" fmla="val 16667"/>
            </a:avLst>
          </a:prstGeom>
          <a:solidFill>
            <a:srgbClr val="66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79" name="AutoShape 8"/>
          <p:cNvSpPr/>
          <p:nvPr/>
        </p:nvSpPr>
        <p:spPr>
          <a:xfrm>
            <a:off x="7086600" y="2590920"/>
            <a:ext cx="2514600" cy="2286000"/>
          </a:xfrm>
          <a:prstGeom prst="roundRect">
            <a:avLst>
              <a:gd name="adj" fmla="val 16667"/>
            </a:avLst>
          </a:prstGeom>
          <a:solidFill>
            <a:srgbClr val="66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80" name="AutoShape 9"/>
          <p:cNvSpPr/>
          <p:nvPr/>
        </p:nvSpPr>
        <p:spPr>
          <a:xfrm>
            <a:off x="7086600" y="4876920"/>
            <a:ext cx="2514600" cy="2286000"/>
          </a:xfrm>
          <a:prstGeom prst="roundRect">
            <a:avLst>
              <a:gd name="adj" fmla="val 16667"/>
            </a:avLst>
          </a:prstGeom>
          <a:solidFill>
            <a:srgbClr val="66ff99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81" name="Rectangle 10"/>
          <p:cNvSpPr/>
          <p:nvPr/>
        </p:nvSpPr>
        <p:spPr>
          <a:xfrm>
            <a:off x="0" y="0"/>
            <a:ext cx="9448920" cy="609480"/>
          </a:xfrm>
          <a:prstGeom prst="rect">
            <a:avLst/>
          </a:prstGeom>
          <a:solidFill>
            <a:srgbClr val="2b2b8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82" name="Text Box 11"/>
          <p:cNvSpPr/>
          <p:nvPr/>
        </p:nvSpPr>
        <p:spPr>
          <a:xfrm>
            <a:off x="685800" y="746280"/>
            <a:ext cx="144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00"/>
                </a:solidFill>
                <a:latin typeface="Arial"/>
              </a:rPr>
              <a:t>Capillary</a:t>
            </a: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83" name="Text Box 12"/>
          <p:cNvSpPr/>
          <p:nvPr/>
        </p:nvSpPr>
        <p:spPr>
          <a:xfrm>
            <a:off x="2666880" y="685800"/>
            <a:ext cx="2514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666633"/>
                </a:solidFill>
                <a:latin typeface="Arial"/>
              </a:rPr>
              <a:t>Distal Tubule Cells</a:t>
            </a: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84" name="Text Box 13"/>
          <p:cNvSpPr/>
          <p:nvPr/>
        </p:nvSpPr>
        <p:spPr>
          <a:xfrm>
            <a:off x="5181480" y="6248520"/>
            <a:ext cx="190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70c0"/>
                </a:solidFill>
                <a:latin typeface="Arial"/>
              </a:rPr>
              <a:t>Tubular Urine</a:t>
            </a: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85" name="Text Box 14"/>
          <p:cNvSpPr/>
          <p:nvPr/>
        </p:nvSpPr>
        <p:spPr>
          <a:xfrm>
            <a:off x="5638680" y="1371600"/>
            <a:ext cx="990720" cy="57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0066"/>
                </a:solidFill>
                <a:latin typeface="Arial"/>
              </a:rPr>
              <a:t>NH</a:t>
            </a:r>
            <a:r>
              <a:rPr b="0" lang="en-US" sz="2800" spc="-1" strike="noStrike" baseline="-25000">
                <a:solidFill>
                  <a:srgbClr val="ff0066"/>
                </a:solidFill>
                <a:latin typeface="Arial"/>
              </a:rPr>
              <a:t>3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86" name="Text Box 15"/>
          <p:cNvSpPr/>
          <p:nvPr/>
        </p:nvSpPr>
        <p:spPr>
          <a:xfrm>
            <a:off x="5257800" y="3200400"/>
            <a:ext cx="8380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0066"/>
                </a:solidFill>
                <a:latin typeface="Arial"/>
              </a:rPr>
              <a:t>Na</a:t>
            </a:r>
            <a:r>
              <a:rPr b="0" lang="en-US" sz="2800" spc="-1" strike="noStrike" baseline="30000">
                <a:solidFill>
                  <a:srgbClr val="ff0066"/>
                </a:solidFill>
                <a:latin typeface="Arial"/>
              </a:rPr>
              <a:t>+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87" name="Text Box 16"/>
          <p:cNvSpPr/>
          <p:nvPr/>
        </p:nvSpPr>
        <p:spPr>
          <a:xfrm>
            <a:off x="6400800" y="3200400"/>
            <a:ext cx="6858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0066"/>
                </a:solidFill>
                <a:latin typeface="Arial"/>
              </a:rPr>
              <a:t>Cl</a:t>
            </a:r>
            <a:r>
              <a:rPr b="0" lang="en-US" sz="2800" spc="-1" strike="noStrike" baseline="30000">
                <a:solidFill>
                  <a:srgbClr val="ff0066"/>
                </a:solidFill>
                <a:latin typeface="Arial"/>
              </a:rPr>
              <a:t>-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88" name="Text Box 17"/>
          <p:cNvSpPr/>
          <p:nvPr/>
        </p:nvSpPr>
        <p:spPr>
          <a:xfrm>
            <a:off x="6019920" y="3200400"/>
            <a:ext cx="3808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+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89" name="Text Box 18"/>
          <p:cNvSpPr/>
          <p:nvPr/>
        </p:nvSpPr>
        <p:spPr>
          <a:xfrm>
            <a:off x="3276720" y="3475080"/>
            <a:ext cx="1295280" cy="57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66ff"/>
                </a:solidFill>
                <a:latin typeface="Arial"/>
              </a:rPr>
              <a:t>H</a:t>
            </a:r>
            <a:r>
              <a:rPr b="0" lang="en-US" sz="2800" spc="-1" strike="noStrike" baseline="-25000">
                <a:solidFill>
                  <a:srgbClr val="0066ff"/>
                </a:solidFill>
                <a:latin typeface="Arial"/>
              </a:rPr>
              <a:t>2</a:t>
            </a:r>
            <a:r>
              <a:rPr b="0" lang="en-US" sz="2800" spc="-1" strike="noStrike">
                <a:solidFill>
                  <a:srgbClr val="0066ff"/>
                </a:solidFill>
                <a:latin typeface="Arial"/>
              </a:rPr>
              <a:t>CO</a:t>
            </a:r>
            <a:r>
              <a:rPr b="0" lang="en-US" sz="2800" spc="-1" strike="noStrike" baseline="-25000">
                <a:solidFill>
                  <a:srgbClr val="0066ff"/>
                </a:solidFill>
                <a:latin typeface="Arial"/>
              </a:rPr>
              <a:t>3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90" name="Text Box 19"/>
          <p:cNvSpPr/>
          <p:nvPr/>
        </p:nvSpPr>
        <p:spPr>
          <a:xfrm>
            <a:off x="2895480" y="3519360"/>
            <a:ext cx="1295640" cy="57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b050"/>
                </a:solidFill>
                <a:latin typeface="Arial"/>
              </a:rPr>
              <a:t>HCO</a:t>
            </a:r>
            <a:r>
              <a:rPr b="0" lang="en-US" sz="2800" spc="-1" strike="noStrike" baseline="-25000">
                <a:solidFill>
                  <a:srgbClr val="00b050"/>
                </a:solidFill>
                <a:latin typeface="Arial"/>
              </a:rPr>
              <a:t>3</a:t>
            </a:r>
            <a:r>
              <a:rPr b="0" lang="en-US" sz="2800" spc="-1" strike="noStrike" baseline="30000">
                <a:solidFill>
                  <a:srgbClr val="00b050"/>
                </a:solidFill>
                <a:latin typeface="Arial"/>
              </a:rPr>
              <a:t>-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91" name="Text Box 20"/>
          <p:cNvSpPr/>
          <p:nvPr/>
        </p:nvSpPr>
        <p:spPr>
          <a:xfrm>
            <a:off x="3994200" y="3517920"/>
            <a:ext cx="3808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+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92" name="Text Box 21"/>
          <p:cNvSpPr/>
          <p:nvPr/>
        </p:nvSpPr>
        <p:spPr>
          <a:xfrm>
            <a:off x="5562720" y="3214800"/>
            <a:ext cx="12189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666633"/>
                </a:solidFill>
                <a:latin typeface="Arial"/>
              </a:rPr>
              <a:t>NaCl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93" name="Text Box 22"/>
          <p:cNvSpPr/>
          <p:nvPr/>
        </p:nvSpPr>
        <p:spPr>
          <a:xfrm>
            <a:off x="3124080" y="4114800"/>
            <a:ext cx="1828800" cy="579600"/>
          </a:xfrm>
          <a:prstGeom prst="rect">
            <a:avLst/>
          </a:prstGeom>
          <a:solidFill>
            <a:srgbClr val="66ff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Arial"/>
              </a:rPr>
              <a:t>NaHCO</a:t>
            </a:r>
            <a:r>
              <a:rPr b="0" lang="en-US" sz="2800" spc="-1" strike="noStrike" baseline="-25000">
                <a:solidFill>
                  <a:srgbClr val="ffffff"/>
                </a:solidFill>
                <a:latin typeface="Arial"/>
              </a:rPr>
              <a:t>3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94" name="Text Box 23"/>
          <p:cNvSpPr/>
          <p:nvPr/>
        </p:nvSpPr>
        <p:spPr>
          <a:xfrm>
            <a:off x="914400" y="5715000"/>
            <a:ext cx="2895480" cy="825480"/>
          </a:xfrm>
          <a:prstGeom prst="rect">
            <a:avLst/>
          </a:prstGeom>
          <a:solidFill>
            <a:srgbClr val="ffcccc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"/>
              </a:rPr>
              <a:t>Click Mouse to Start Animation</a:t>
            </a:r>
            <a:endParaRPr b="0" lang="en-US" sz="24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95" name="Text Box 24"/>
          <p:cNvSpPr/>
          <p:nvPr/>
        </p:nvSpPr>
        <p:spPr>
          <a:xfrm>
            <a:off x="3124080" y="4181400"/>
            <a:ext cx="1828800" cy="457200"/>
          </a:xfrm>
          <a:prstGeom prst="rect">
            <a:avLst/>
          </a:prstGeom>
          <a:solidFill>
            <a:srgbClr val="66ff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96" name="Text Box 25"/>
          <p:cNvSpPr/>
          <p:nvPr/>
        </p:nvSpPr>
        <p:spPr>
          <a:xfrm>
            <a:off x="3124080" y="4119480"/>
            <a:ext cx="1828800" cy="57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b050"/>
                </a:solidFill>
                <a:latin typeface="Arial"/>
              </a:rPr>
              <a:t>NaHCO</a:t>
            </a:r>
            <a:r>
              <a:rPr b="0" lang="en-US" sz="2800" spc="-1" strike="noStrike" baseline="-25000">
                <a:solidFill>
                  <a:srgbClr val="00b050"/>
                </a:solidFill>
                <a:latin typeface="Arial"/>
              </a:rPr>
              <a:t>3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97" name="Text Box 26"/>
          <p:cNvSpPr/>
          <p:nvPr/>
        </p:nvSpPr>
        <p:spPr>
          <a:xfrm>
            <a:off x="5410080" y="4648320"/>
            <a:ext cx="1524240" cy="57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c00000"/>
                </a:solidFill>
                <a:latin typeface="Arial"/>
              </a:rPr>
              <a:t>NH</a:t>
            </a:r>
            <a:r>
              <a:rPr b="0" lang="en-US" sz="2800" spc="-1" strike="noStrike" baseline="-25000">
                <a:solidFill>
                  <a:srgbClr val="c00000"/>
                </a:solidFill>
                <a:latin typeface="Arial"/>
              </a:rPr>
              <a:t>3</a:t>
            </a:r>
            <a:r>
              <a:rPr b="0" lang="en-US" sz="2800" spc="-1" strike="noStrike">
                <a:solidFill>
                  <a:srgbClr val="c00000"/>
                </a:solidFill>
                <a:latin typeface="Arial"/>
              </a:rPr>
              <a:t>Cl</a:t>
            </a:r>
            <a:r>
              <a:rPr b="0" lang="en-US" sz="2800" spc="-1" strike="noStrike" baseline="30000">
                <a:solidFill>
                  <a:srgbClr val="c00000"/>
                </a:solidFill>
                <a:latin typeface="Arial"/>
              </a:rPr>
              <a:t>-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98" name="Text Box 27"/>
          <p:cNvSpPr/>
          <p:nvPr/>
        </p:nvSpPr>
        <p:spPr>
          <a:xfrm>
            <a:off x="4343400" y="3519360"/>
            <a:ext cx="6094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0000"/>
                </a:solidFill>
                <a:latin typeface="Arial"/>
              </a:rPr>
              <a:t>H</a:t>
            </a:r>
            <a:r>
              <a:rPr b="0" lang="en-US" sz="2800" spc="-1" strike="noStrike" baseline="30000">
                <a:solidFill>
                  <a:srgbClr val="ff0000"/>
                </a:solidFill>
                <a:latin typeface="Arial"/>
              </a:rPr>
              <a:t>+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199" name="Text Box 28"/>
          <p:cNvSpPr/>
          <p:nvPr/>
        </p:nvSpPr>
        <p:spPr>
          <a:xfrm>
            <a:off x="5410080" y="5195880"/>
            <a:ext cx="1447920" cy="57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0000"/>
                </a:solidFill>
                <a:latin typeface="Arial"/>
              </a:rPr>
              <a:t>NH</a:t>
            </a:r>
            <a:r>
              <a:rPr b="0" lang="en-US" sz="2800" spc="-1" strike="noStrike" baseline="-25000">
                <a:solidFill>
                  <a:srgbClr val="ff0000"/>
                </a:solidFill>
                <a:latin typeface="Arial"/>
              </a:rPr>
              <a:t>4</a:t>
            </a:r>
            <a:r>
              <a:rPr b="0" lang="en-US" sz="2800" spc="-1" strike="noStrike">
                <a:solidFill>
                  <a:srgbClr val="ff0000"/>
                </a:solidFill>
                <a:latin typeface="Arial"/>
              </a:rPr>
              <a:t>Cl</a:t>
            </a:r>
            <a:endParaRPr b="0" lang="en-US" sz="28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200" name="Text Box 29"/>
          <p:cNvSpPr/>
          <p:nvPr/>
        </p:nvSpPr>
        <p:spPr>
          <a:xfrm>
            <a:off x="914400" y="5715000"/>
            <a:ext cx="3276720" cy="825480"/>
          </a:xfrm>
          <a:prstGeom prst="rect">
            <a:avLst/>
          </a:prstGeom>
          <a:solidFill>
            <a:srgbClr val="ffcccc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7030a0"/>
                </a:solidFill>
                <a:latin typeface="Arial"/>
              </a:rPr>
              <a:t>Click to See Animation Again</a:t>
            </a:r>
            <a:endParaRPr b="0" lang="en-US" sz="2400" spc="-1" strike="noStrike">
              <a:solidFill>
                <a:srgbClr val="ffffff"/>
              </a:solidFill>
              <a:latin typeface="굴림"/>
            </a:endParaRPr>
          </a:p>
        </p:txBody>
      </p:sp>
      <p:sp>
        <p:nvSpPr>
          <p:cNvPr id="201" name="Text Box 30"/>
          <p:cNvSpPr/>
          <p:nvPr/>
        </p:nvSpPr>
        <p:spPr>
          <a:xfrm>
            <a:off x="7010280" y="609480"/>
            <a:ext cx="2278080" cy="228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Notice the</a:t>
            </a:r>
            <a:br>
              <a:rPr sz="2400"/>
            </a:b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0" lang="en-US" sz="24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- Na</a:t>
            </a:r>
            <a:r>
              <a:rPr b="0" lang="en-US" sz="24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exchange to  maintain electrical neutrality</a:t>
            </a:r>
            <a:endParaRPr b="0" lang="en-US" sz="2400" spc="-1" strike="noStrike">
              <a:solidFill>
                <a:srgbClr val="ffffff"/>
              </a:solidFill>
              <a:latin typeface="굴림"/>
            </a:endParaRPr>
          </a:p>
        </p:txBody>
      </p:sp>
      <p:pic>
        <p:nvPicPr>
          <p:cNvPr id="202" name="Picture 31" descr="rbc"/>
          <p:cNvPicPr/>
          <p:nvPr/>
        </p:nvPicPr>
        <p:blipFill>
          <a:blip r:embed="rId1"/>
          <a:srcRect l="0" t="0" r="51353" b="45224"/>
          <a:stretch/>
        </p:blipFill>
        <p:spPr>
          <a:xfrm>
            <a:off x="914400" y="-1066680"/>
            <a:ext cx="549360" cy="609480"/>
          </a:xfrm>
          <a:prstGeom prst="rect">
            <a:avLst/>
          </a:prstGeom>
          <a:ln w="0">
            <a:noFill/>
          </a:ln>
        </p:spPr>
      </p:pic>
      <p:pic>
        <p:nvPicPr>
          <p:cNvPr id="203" name="Picture 32" descr="rbc"/>
          <p:cNvPicPr/>
          <p:nvPr/>
        </p:nvPicPr>
        <p:blipFill>
          <a:blip r:embed="rId2"/>
          <a:srcRect l="0" t="0" r="51353" b="45224"/>
          <a:stretch/>
        </p:blipFill>
        <p:spPr>
          <a:xfrm rot="19830600">
            <a:off x="1600200" y="-1219320"/>
            <a:ext cx="549360" cy="609840"/>
          </a:xfrm>
          <a:prstGeom prst="rect">
            <a:avLst/>
          </a:prstGeom>
          <a:ln w="0">
            <a:noFill/>
          </a:ln>
        </p:spPr>
      </p:pic>
      <p:pic>
        <p:nvPicPr>
          <p:cNvPr id="204" name="Picture 33" descr="rbc"/>
          <p:cNvPicPr/>
          <p:nvPr/>
        </p:nvPicPr>
        <p:blipFill>
          <a:blip r:embed="rId3"/>
          <a:srcRect l="0" t="0" r="51353" b="45224"/>
          <a:stretch/>
        </p:blipFill>
        <p:spPr>
          <a:xfrm rot="19806000">
            <a:off x="456840" y="-609480"/>
            <a:ext cx="549360" cy="609480"/>
          </a:xfrm>
          <a:prstGeom prst="rect">
            <a:avLst/>
          </a:prstGeom>
          <a:ln w="0">
            <a:noFill/>
          </a:ln>
        </p:spPr>
      </p:pic>
      <p:pic>
        <p:nvPicPr>
          <p:cNvPr id="205" name="Picture 34" descr="rbc"/>
          <p:cNvPicPr/>
          <p:nvPr/>
        </p:nvPicPr>
        <p:blipFill>
          <a:blip r:embed="rId4"/>
          <a:srcRect l="51367" t="45210" r="0" b="0"/>
          <a:stretch/>
        </p:blipFill>
        <p:spPr>
          <a:xfrm rot="19103400">
            <a:off x="334440" y="-1523880"/>
            <a:ext cx="549360" cy="609480"/>
          </a:xfrm>
          <a:prstGeom prst="rect">
            <a:avLst/>
          </a:prstGeom>
          <a:ln w="0">
            <a:noFill/>
          </a:ln>
        </p:spPr>
      </p:pic>
      <p:pic>
        <p:nvPicPr>
          <p:cNvPr id="206" name="Picture 35" descr="rbc"/>
          <p:cNvPicPr/>
          <p:nvPr/>
        </p:nvPicPr>
        <p:blipFill>
          <a:blip r:embed="rId5"/>
          <a:srcRect l="45210" t="0" r="0" b="51367"/>
          <a:stretch/>
        </p:blipFill>
        <p:spPr>
          <a:xfrm rot="19191000">
            <a:off x="1371240" y="-549360"/>
            <a:ext cx="609480" cy="549360"/>
          </a:xfrm>
          <a:prstGeom prst="rect">
            <a:avLst/>
          </a:prstGeom>
          <a:ln w="0">
            <a:noFill/>
          </a:ln>
        </p:spPr>
      </p:pic>
      <p:pic>
        <p:nvPicPr>
          <p:cNvPr id="207" name="Picture 36" descr="rbc"/>
          <p:cNvPicPr/>
          <p:nvPr/>
        </p:nvPicPr>
        <p:blipFill>
          <a:blip r:embed="rId6"/>
          <a:srcRect l="0" t="51367" r="45210" b="0"/>
          <a:stretch/>
        </p:blipFill>
        <p:spPr>
          <a:xfrm rot="346200">
            <a:off x="1066680" y="-1874520"/>
            <a:ext cx="609840" cy="549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91" dur="indefinite" restart="never" nodeType="tmRoot">
          <p:childTnLst>
            <p:seq>
              <p:cTn id="192" dur="indefinite" nodeType="mainSeq">
                <p:childTnLst>
                  <p:par>
                    <p:cTn id="193" fill="hold">
                      <p:stCondLst>
                        <p:cond delay="indefinite"/>
                      </p:stCondLst>
                      <p:childTnLst>
                        <p:par>
                          <p:cTn id="194" fill="hold">
                            <p:stCondLst>
                              <p:cond delay="0"/>
                            </p:stCondLst>
                            <p:childTnLst>
                              <p:par>
                                <p:cTn id="195" nodeType="clickEffect" fill="hold" presetClass="exit" presetID="1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196" dur="2000"/>
                                        <p:tgtEl>
                                          <p:spTgt spid="19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97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9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8" nodeType="withEffect" fill="hold" presetClass="emph" presetID="8" repeatCount="indefinite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199" dur="2000" fill="hold"/>
                                        <p:tgtEl>
                                          <p:spTgt spid="205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00" nodeType="withEffect" fill="hold" presetClass="emph" presetID="8" repeatCount="indefinite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201" dur="2000" fill="hold"/>
                                        <p:tgtEl>
                                          <p:spTgt spid="207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02" nodeType="withEffect" fill="hold" presetClass="emph" presetID="8" repeatCount="indefinite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203" dur="2000" fill="hold"/>
                                        <p:tgtEl>
                                          <p:spTgt spid="20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04" nodeType="withEffect" fill="hold" presetClass="emph" presetID="8" repeatCount="indefinite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205" dur="2000" fill="hold"/>
                                        <p:tgtEl>
                                          <p:spTgt spid="202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06" nodeType="withEffect" fill="hold" presetClass="emph" presetID="8" repeatCount="indefinite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207" dur="2000" fill="hold"/>
                                        <p:tgtEl>
                                          <p:spTgt spid="20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08" nodeType="withEffect" fill="hold" presetClass="emph" presetID="8" repeatCount="indefinite">
                                  <p:stCondLst>
                                    <p:cond delay="0"/>
                                  </p:stCondLst>
                                  <p:childTnLst>
                                    <p:animRot by="21600000">
                                      <p:cBhvr>
                                        <p:cTn id="209" dur="2000" fill="hold"/>
                                        <p:tgtEl>
                                          <p:spTgt spid="206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10" nodeType="withEffect" fill="hold" presetClass="path" presetID="0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1562 -0.20417 C -0.01424 -0.15093 -0.01319 0.03865 -0.00764 0.1199 C -0.00208 0.20115 0.00903 0.22129 0.01736 0.28333 C 0.02569 0.34537 0.04601 0.43333 0.04236 0.49328 C 0.03872 0.55324 0.00747 0.59004 -0.00503 0.64328 C -0.01753 0.69606 -0.0276 0.76041 -0.03264 0.81296 C -0.03767 0.86574 -0.03299 0.91041 -0.03507 0.95995 C -0.03715 1.00949 -0.04635 1.06944 -0.04514 1.10995 C -0.04392 1.15023 -0.03264 1.15208 -0.0276 1.20324 C -0.02257 1.25439 -0.01927 1.37222 -0.0151 1.41666 C -0.01094 1.46111 -0.00677 1.46551 -0.0026 1.4699 E">
                                      <p:cBhvr>
                                        <p:cTn id="211" dur="3000" fill="hold"/>
                                        <p:tgtEl>
                                          <p:spTgt spid="207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212" nodeType="withEffect" fill="hold" presetClass="path" presetID="0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1685 -0.17917 C 0.01042 -0.10903 -0.00503 0.14722 -0.02187 0.24583 C -0.03871 0.34444 -0.06927 0.3493 -0.08437 0.4125 C -0.09947 0.47569 -0.11406 0.5493 -0.1125 0.625 C -0.11093 0.70069 -0.09375 0.80208 -0.075 0.86666 C -0.05625 0.93125 -0.01406 0.95555 -4.72222E-006 1.0125 C 0.01407 1.06944 0.01164 1.13889 0.00938 1.20833 E">
                                      <p:cBhvr>
                                        <p:cTn id="213" dur="3000" fill="hold"/>
                                        <p:tgtEl>
                                          <p:spTgt spid="203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214" nodeType="withEffect" fill="hold" presetClass="path" presetID="0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33333E-006 3.7037E-006 C -0.03281 0.06505 -0.06562 0.13032 -0.075 0.1875 C -0.08437 0.24444 -0.06875 0.27986 -0.05625 0.34167 C -0.04375 0.40324 -0.01354 0.49028 3.33333E-006 0.55833 C 0.01354 0.62639 0.01979 0.68472 0.025 0.75 C 0.03021 0.81505 0.03646 0.89074 0.03125 0.95 C 0.02604 1.00903 0.0099 1.05648 -0.00625 1.10417 E">
                                      <p:cBhvr>
                                        <p:cTn id="215" dur="3000" fill="hold"/>
                                        <p:tgtEl>
                                          <p:spTgt spid="206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216" nodeType="withEffect" fill="hold" presetClass="path" presetID="0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9.72222E-006 -1.11111E-006 C -0.02187 0.08403 -0.04374 0.16806 -0.05312 0.2375 C -0.06249 0.30694 -0.06041 0.35347 -0.05624 0.41667 C -0.05208 0.47986 -0.0427 0.54931 -0.02812 0.61667 C -0.01354 0.68403 0.01198 0.74861 0.03126 0.82083 C 0.05053 0.89306 0.07084 0.98958 0.08751 1.05 C 0.10417 1.11042 0.11771 1.14676 0.13126 1.18333 E">
                                      <p:cBhvr>
                                        <p:cTn id="217" dur="3000" fill="hold"/>
                                        <p:tgtEl>
                                          <p:spTgt spid="202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218" nodeType="withEffect" fill="hold" presetClass="path" presetID="0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3542 -0.13055 C -0.02327 -0.08102 0.01597 0.09144 0.04062 0.17084 C 0.06527 0.25023 0.09375 0.29028 0.1125 0.34584 C 0.13125 0.40139 0.14896 0.44097 0.15312 0.50394 C 0.15729 0.56713 0.15104 0.64653 0.1375 0.72477 C 0.12396 0.80347 0.09635 0.89931 0.07187 0.975 C 0.04739 1.05047 0.00781 1.13172 -0.00938 1.17917 C -0.02657 1.22639 -0.029 1.24236 -0.03125 1.25834 E">
                                      <p:cBhvr>
                                        <p:cTn id="219" dur="3000" fill="hold"/>
                                        <p:tgtEl>
                                          <p:spTgt spid="205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220" nodeType="withEffect" fill="hold" presetClass="path" presetID="0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9.72222E-006 -7.77778E-006 C 0.02101 0.0611 0.04219 0.12222 0.05626 0.24583 C 0.07032 0.36944 0.07969 0.59791 0.08438 0.74166 C 0.08907 0.88518 0.08664 0.99675 0.08438 1.10833 E">
                                      <p:cBhvr>
                                        <p:cTn id="221" dur="3000" fill="hold"/>
                                        <p:tgtEl>
                                          <p:spTgt spid="204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22" fill="hold">
                            <p:stCondLst>
                              <p:cond delay="3000"/>
                            </p:stCondLst>
                            <p:childTnLst>
                              <p:par>
                                <p:cTn id="223" nodeType="afterEffect" fill="hold" presetClass="exit" presetID="1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224" dur="2000"/>
                                        <p:tgtEl>
                                          <p:spTgt spid="189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25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8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26" nodeType="with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228" dur="2000"/>
                                        <p:tgtEl>
                                          <p:spTgt spid="19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29" nodeType="with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231" dur="2000"/>
                                        <p:tgtEl>
                                          <p:spTgt spid="19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32" nodeType="with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234" dur="2000"/>
                                        <p:tgtEl>
                                          <p:spTgt spid="19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35" fill="hold">
                            <p:stCondLst>
                              <p:cond delay="5000"/>
                            </p:stCondLst>
                            <p:childTnLst>
                              <p:par>
                                <p:cTn id="236" nodeType="afterEffect" fill="hold" presetClass="exit" presetID="10">
                                  <p:stCondLst>
                                    <p:cond delay="200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237" dur="2000"/>
                                        <p:tgtEl>
                                          <p:spTgt spid="19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38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9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39" fill="hold">
                            <p:stCondLst>
                              <p:cond delay="9000"/>
                            </p:stCondLst>
                            <p:childTnLst>
                              <p:par>
                                <p:cTn id="240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5.55112E-017 4.07407E-006 C -0.00417 0.01782 -0.00729 0.03912 -0.00486 0.05347 C -0.00243 0.06782 0.00538 0.07916 0.01493 0.08564 C 0.02448 0.09213 0.04462 0.09097 0.05243 0.09236 E">
                                      <p:cBhvr>
                                        <p:cTn id="241" dur="3000" fill="hold"/>
                                        <p:tgtEl>
                                          <p:spTgt spid="190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42" fill="hold">
                            <p:stCondLst>
                              <p:cond delay="12000"/>
                            </p:stCondLst>
                            <p:childTnLst>
                              <p:par>
                                <p:cTn id="243" nodeType="afterEffect" fill="hold" presetClass="exit" presetID="1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244" dur="2000"/>
                                        <p:tgtEl>
                                          <p:spTgt spid="192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45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9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46" nodeType="with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248" dur="2000"/>
                                        <p:tgtEl>
                                          <p:spTgt spid="18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49" nodeType="with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251" dur="2000"/>
                                        <p:tgtEl>
                                          <p:spTgt spid="18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52" nodeType="with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254" dur="2000"/>
                                        <p:tgtEl>
                                          <p:spTgt spid="18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55" fill="hold">
                            <p:stCondLst>
                              <p:cond delay="14000"/>
                            </p:stCondLst>
                            <p:childTnLst>
                              <p:par>
                                <p:cTn id="256" nodeType="afterEffect" fill="hold" presetClass="exit" presetID="10">
                                  <p:stCondLst>
                                    <p:cond delay="200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257" dur="2000"/>
                                        <p:tgtEl>
                                          <p:spTgt spid="188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58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8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59" fill="hold">
                            <p:stCondLst>
                              <p:cond delay="18000"/>
                            </p:stCondLst>
                            <p:childTnLst>
                              <p:par>
                                <p:cTn id="260" nodeType="after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262" dur="2000"/>
                                        <p:tgtEl>
                                          <p:spTgt spid="20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63" fill="hold">
                            <p:stCondLst>
                              <p:cond delay="20000"/>
                            </p:stCondLst>
                            <p:childTnLst>
                              <p:par>
                                <p:cTn id="264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33333E-006 1.85185E-006 C -0.02847 0.01227 -0.05677 0.02454 -0.08264 0.0368 C -0.1085 0.04907 -0.13784 0.05579 -0.15503 0.07338 C -0.17222 0.09097 -0.17934 0.12801 -0.18576 0.14236 E">
                                      <p:cBhvr>
                                        <p:cTn id="265" dur="2000" fill="hold"/>
                                        <p:tgtEl>
                                          <p:spTgt spid="186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66" fill="hold">
                            <p:stCondLst>
                              <p:cond delay="22000"/>
                            </p:stCondLst>
                            <p:childTnLst>
                              <p:par>
                                <p:cTn id="267" nodeType="after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269" dur="2000"/>
                                        <p:tgtEl>
                                          <p:spTgt spid="19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70" fill="hold">
                            <p:stCondLst>
                              <p:cond delay="24000"/>
                            </p:stCondLst>
                            <p:childTnLst>
                              <p:par>
                                <p:cTn id="271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33333E-006 -1.48148E-006 C 0.02205 0.04236 0.0441 0.08496 0.0375 0.10996 C 0.03091 0.13496 -0.02552 0.11945 -0.0401 0.15 C -0.05468 0.18056 -0.06302 0.25394 -0.05 0.29329 C -0.03698 0.33264 0.02657 0.3544 0.0375 0.38658 C 0.04844 0.41875 0.02014 0.46528 0.01563 0.48588 E">
                                      <p:cBhvr>
                                        <p:cTn id="272" dur="3000" fill="hold"/>
                                        <p:tgtEl>
                                          <p:spTgt spid="185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73" fill="hold">
                            <p:stCondLst>
                              <p:cond delay="27000"/>
                            </p:stCondLst>
                            <p:childTnLst>
                              <p:par>
                                <p:cTn id="274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1.85185E-006 C 0.01684 0.03055 0.03385 0.06111 0.0276 0.08009 C 0.02135 0.09907 -0.01701 0.10185 -0.0375 0.11342 C -0.05799 0.125 -0.09028 0.13241 -0.09497 0.15 C -0.09965 0.16759 -0.0717 0.20486 -0.06562 0.21921 E">
                                      <p:cBhvr>
                                        <p:cTn id="275" dur="3000" fill="hold"/>
                                        <p:tgtEl>
                                          <p:spTgt spid="187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76" fill="hold">
                            <p:stCondLst>
                              <p:cond delay="30000"/>
                            </p:stCondLst>
                            <p:childTnLst>
                              <p:par>
                                <p:cTn id="277" nodeType="after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279" dur="2000"/>
                                        <p:tgtEl>
                                          <p:spTgt spid="19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80" nodeType="withEffect" fill="hold" presetClass="exit" presetID="1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281" dur="2000"/>
                                        <p:tgtEl>
                                          <p:spTgt spid="185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82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8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83" nodeType="withEffect" fill="hold" presetClass="exit" presetID="1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284" dur="2000"/>
                                        <p:tgtEl>
                                          <p:spTgt spid="187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85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8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86" fill="hold">
                            <p:stCondLst>
                              <p:cond delay="32000"/>
                            </p:stCondLst>
                            <p:childTnLst>
                              <p:par>
                                <p:cTn id="287" nodeType="after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89" fill="hold">
                            <p:stCondLst>
                              <p:cond delay="32000"/>
                            </p:stCondLst>
                            <p:childTnLst>
                              <p:par>
                                <p:cTn id="290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33333E-006 4.07407E-006 C 0.00903 0.00138 0.03438 0.0037 0.05417 0.00902 C 0.07396 0.01435 0.1125 0.01527 0.1191 0.0324 C 0.1257 0.04953 0.1033 0.08634 0.0941 0.1125 C 0.0849 0.13865 0.05556 0.16481 0.06424 0.18912 C 0.07292 0.21342 0.12952 0.24444 0.1467 0.25902 E">
                                      <p:cBhvr>
                                        <p:cTn id="291" dur="3000" fill="hold"/>
                                        <p:tgtEl>
                                          <p:spTgt spid="198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92" fill="hold">
                            <p:stCondLst>
                              <p:cond delay="35000"/>
                            </p:stCondLst>
                            <p:childTnLst>
                              <p:par>
                                <p:cTn id="293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11022E-016 7.40741E-007 C 0.00122 0.00856 0.00781 0.03588 0.00747 0.05116 C 0.00712 0.06643 -0.00035 0.08287 -0.00243 0.0912 E">
                                      <p:cBhvr>
                                        <p:cTn id="294" dur="2000" fill="hold"/>
                                        <p:tgtEl>
                                          <p:spTgt spid="197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95" fill="hold">
                            <p:stCondLst>
                              <p:cond delay="37000"/>
                            </p:stCondLst>
                            <p:childTnLst>
                              <p:par>
                                <p:cTn id="296" nodeType="after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9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298" dur="2000"/>
                                        <p:tgtEl>
                                          <p:spTgt spid="19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99" fill="hold">
                            <p:stCondLst>
                              <p:cond delay="39000"/>
                            </p:stCondLst>
                            <p:childTnLst>
                              <p:par>
                                <p:cTn id="300" nodeType="afterEffect" fill="hold" presetClass="exit" presetID="1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301" dur="2000"/>
                                        <p:tgtEl>
                                          <p:spTgt spid="197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02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9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03" nodeType="withEffect" fill="hold" presetClass="exit" presetID="10">
                                  <p:stCondLst>
                                    <p:cond delay="0"/>
                                  </p:stCondLst>
                                  <p:childTnLst>
                                    <p:animEffect filter="fade" transition="out">
                                      <p:cBhvr additive="repl">
                                        <p:cTn id="304" dur="2000"/>
                                        <p:tgtEl>
                                          <p:spTgt spid="198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05" dur="1" fill="hold">
                                          <p:stCondLst>
                                            <p:cond delay="1999"/>
                                          </p:stCondLst>
                                        </p:cTn>
                                        <p:tgtEl>
                                          <p:spTgt spid="19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06" nodeType="with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308" dur="2000"/>
                                        <p:tgtEl>
                                          <p:spTgt spid="19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09" fill="hold">
                            <p:stCondLst>
                              <p:cond delay="41000"/>
                            </p:stCondLst>
                            <p:childTnLst>
                              <p:par>
                                <p:cTn id="310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33333E-006 -4.44444E-006 C -0.00816 0.00741 -0.03473 0.0338 -0.04914 0.04468 C -0.06354 0.05556 -0.07084 0.06366 -0.08664 0.06482 C -0.10261 0.06598 -0.12153 0.05741 -0.14427 0.05139 C -0.16667 0.04537 -0.19514 0.04908 -0.2217 0.02801 C -0.24827 0.00695 -0.28924 -0.103 -0.30417 -0.07523 C -0.3191 -0.04745 -0.31042 0.11412 -0.31164 0.19468 C -0.31285 0.27524 -0.31164 0.36366 -0.31164 0.40811 E">
                                      <p:cBhvr>
                                        <p:cTn id="311" dur="5100" fill="hold"/>
                                        <p:tgtEl>
                                          <p:spTgt spid="196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12" fill="hold">
                            <p:stCondLst>
                              <p:cond delay="46100"/>
                            </p:stCondLst>
                            <p:childTnLst>
                              <p:par>
                                <p:cTn id="313" nodeType="afterEffect" fill="hold" presetClass="path" presetID="0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0 C 0.02204 -0.03056 0.04427 -0.06111 0.04253 -0.09676 C 0.04079 -0.13241 -0.004 -0.17338 -0.0099 -0.21343 C -0.0158 -0.25347 0.00781 -0.3 0.00746 -0.33657 C 0.00711 -0.37315 -0.00539 -0.40324 -0.0125 -0.43333 C -0.01962 -0.46343 -0.03941 -0.49005 -0.0349 -0.51667 C -0.03039 -0.54329 0.0052 -0.56597 0.0151 -0.59329 C 0.025 -0.6206 0.02916 -0.65463 0.025 -0.68009 C 0.02083 -0.70556 -0.00244 -0.72569 -0.0099 -0.74676 C -0.01737 -0.76782 -0.01997 -0.7912 -0.01997 -0.80671 C -0.01997 -0.82199 -0.01494 -0.83125 -0.0099 -0.84005 E">
                                      <p:cBhvr>
                                        <p:cTn id="314" dur="3000" fill="hold"/>
                                        <p:tgtEl>
                                          <p:spTgt spid="199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15" fill="hold">
                            <p:stCondLst>
                              <p:cond delay="49100"/>
                            </p:stCondLst>
                            <p:childTnLst>
                              <p:par>
                                <p:cTn id="316" nodeType="after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318" dur="2000"/>
                                        <p:tgtEl>
                                          <p:spTgt spid="20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PlaceHolder 1"/>
          <p:cNvSpPr>
            <a:spLocks noGrp="1"/>
          </p:cNvSpPr>
          <p:nvPr>
            <p:ph/>
          </p:nvPr>
        </p:nvSpPr>
        <p:spPr>
          <a:xfrm>
            <a:off x="722160" y="2906280"/>
            <a:ext cx="7772400" cy="150012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rmAutofit/>
          </a:bodyPr>
          <a:p>
            <a:pPr indent="0">
              <a:lnSpc>
                <a:spcPct val="10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Arial Black"/>
                <a:ea typeface="굴림"/>
              </a:rPr>
              <a:t>Special thanks to Terry Wiseth for animation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9" name="Slide Number Placeholder 3"/>
          <p:cNvSpPr/>
          <p:nvPr/>
        </p:nvSpPr>
        <p:spPr>
          <a:xfrm>
            <a:off x="67816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9778132-10D2-4B5F-A7AA-6028EDA891D2}" type="slidenum">
              <a:rPr b="0" lang="en-US" sz="10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ffffff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13T13:44:55Z</dcterms:created>
  <dc:creator>amit</dc:creator>
  <dc:description/>
  <dc:language>en-US</dc:language>
  <cp:lastModifiedBy>ghjeong</cp:lastModifiedBy>
  <dcterms:modified xsi:type="dcterms:W3CDTF">2009-12-21T14:14:56Z</dcterms:modified>
  <cp:revision>20</cp:revision>
  <dc:subject/>
  <dc:title>Slide 1</dc:title>
</cp:coreProperties>
</file>